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7772400" cy="10058400"/>
  <p:notesSz cx="7772400" cy="100584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9"/>
  </p:normalViewPr>
  <p:slideViewPr>
    <p:cSldViewPr>
      <p:cViewPr>
        <p:scale>
          <a:sx n="110" d="100"/>
          <a:sy n="110" d="100"/>
        </p:scale>
        <p:origin x="2152" y="-102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402138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D53726-02E0-9B4E-AE6E-D7A612001805}" type="datetimeFigureOut">
              <a:rPr lang="en-US" smtClean="0"/>
              <a:t>10/10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74925" y="1257300"/>
            <a:ext cx="2622550" cy="339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77875" y="4840288"/>
            <a:ext cx="6216650" cy="39608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402138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EA37AD-A200-C946-8B95-3EF2D537C8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383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EA37AD-A200-C946-8B95-3EF2D537C85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4180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82930" y="3118104"/>
            <a:ext cx="6606540" cy="211226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65860" y="5632704"/>
            <a:ext cx="5440680" cy="25146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0/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0/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88620" y="2313432"/>
            <a:ext cx="3380994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002786" y="2313432"/>
            <a:ext cx="3380994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0/23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0/23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0/23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88620" y="402336"/>
            <a:ext cx="6995160" cy="16093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88620" y="2313432"/>
            <a:ext cx="6995160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642616" y="9354312"/>
            <a:ext cx="2487168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88620" y="9354312"/>
            <a:ext cx="1787652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0/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5596128" y="9354312"/>
            <a:ext cx="1787652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79247" y="6092444"/>
            <a:ext cx="3323590" cy="2553903"/>
          </a:xfrm>
          <a:prstGeom prst="rect">
            <a:avLst/>
          </a:prstGeom>
        </p:spPr>
        <p:txBody>
          <a:bodyPr vert="horz" wrap="square" lIns="0" tIns="14604" rIns="0" bIns="0" rtlCol="0">
            <a:spAutoFit/>
          </a:bodyPr>
          <a:lstStyle/>
          <a:p>
            <a:pPr marL="12700">
              <a:lnSpc>
                <a:spcPts val="1475"/>
              </a:lnSpc>
              <a:spcBef>
                <a:spcPts val="114"/>
              </a:spcBef>
            </a:pPr>
            <a:r>
              <a:rPr sz="1250" b="1" u="sng" spc="-10" dirty="0">
                <a:uFill>
                  <a:solidFill>
                    <a:srgbClr val="000000"/>
                  </a:solidFill>
                </a:uFill>
                <a:latin typeface="Arial"/>
                <a:cs typeface="Arial"/>
              </a:rPr>
              <a:t>Across</a:t>
            </a:r>
            <a:endParaRPr sz="1250" dirty="0">
              <a:latin typeface="Arial"/>
              <a:cs typeface="Arial"/>
            </a:endParaRPr>
          </a:p>
          <a:p>
            <a:pPr marL="136525" marR="372110">
              <a:lnSpc>
                <a:spcPts val="1210"/>
              </a:lnSpc>
              <a:spcBef>
                <a:spcPts val="55"/>
              </a:spcBef>
            </a:pPr>
            <a:r>
              <a:rPr sz="1050" b="1" dirty="0">
                <a:latin typeface="Arial"/>
                <a:cs typeface="Arial"/>
              </a:rPr>
              <a:t>2.</a:t>
            </a:r>
            <a:r>
              <a:rPr sz="1050" b="1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HR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&lt;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100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pm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with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lang="en-US" sz="1050" dirty="0">
                <a:latin typeface="Arial"/>
                <a:cs typeface="Arial"/>
              </a:rPr>
              <a:t>positive pressure ventilation</a:t>
            </a:r>
            <a:r>
              <a:rPr sz="1050" dirty="0">
                <a:latin typeface="Arial"/>
                <a:cs typeface="Arial"/>
              </a:rPr>
              <a:t>;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h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pneumonic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5" dirty="0">
                <a:latin typeface="Arial"/>
                <a:cs typeface="Arial"/>
              </a:rPr>
              <a:t>you </a:t>
            </a:r>
            <a:r>
              <a:rPr sz="1050" dirty="0">
                <a:latin typeface="Arial"/>
                <a:cs typeface="Arial"/>
              </a:rPr>
              <a:t>should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us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ow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is…?</a:t>
            </a:r>
            <a:endParaRPr sz="1050" dirty="0">
              <a:latin typeface="Arial"/>
              <a:cs typeface="Arial"/>
            </a:endParaRPr>
          </a:p>
          <a:p>
            <a:pPr marL="136525" marR="279400">
              <a:lnSpc>
                <a:spcPts val="1210"/>
              </a:lnSpc>
            </a:pPr>
            <a:r>
              <a:rPr sz="1050" b="1" dirty="0">
                <a:latin typeface="Arial"/>
                <a:cs typeface="Arial"/>
              </a:rPr>
              <a:t>5.</a:t>
            </a:r>
            <a:r>
              <a:rPr sz="1050" b="1" spc="-3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pel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maximum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econds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efore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cutting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spc="-25" dirty="0">
                <a:latin typeface="Arial"/>
                <a:cs typeface="Arial"/>
              </a:rPr>
              <a:t>the </a:t>
            </a:r>
            <a:r>
              <a:rPr sz="1050" dirty="0">
                <a:latin typeface="Arial"/>
                <a:cs typeface="Arial"/>
              </a:rPr>
              <a:t>umbilica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cord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a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vigorous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baby</a:t>
            </a:r>
            <a:endParaRPr sz="1050" dirty="0">
              <a:latin typeface="Arial"/>
              <a:cs typeface="Arial"/>
            </a:endParaRPr>
          </a:p>
          <a:p>
            <a:pPr marL="136525" marR="196850">
              <a:lnSpc>
                <a:spcPts val="1210"/>
              </a:lnSpc>
            </a:pPr>
            <a:r>
              <a:rPr sz="1050" b="1" dirty="0">
                <a:latin typeface="Arial"/>
                <a:cs typeface="Arial"/>
              </a:rPr>
              <a:t>6.</a:t>
            </a:r>
            <a:r>
              <a:rPr sz="1050" b="1" spc="-3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pel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maximum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itia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xygen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aturation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spc="-25" dirty="0">
                <a:latin typeface="Arial"/>
                <a:cs typeface="Arial"/>
              </a:rPr>
              <a:t>you </a:t>
            </a:r>
            <a:r>
              <a:rPr sz="1050" dirty="0">
                <a:latin typeface="Arial"/>
                <a:cs typeface="Arial"/>
              </a:rPr>
              <a:t>would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us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for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a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eonat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&lt;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35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weeks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gestation</a:t>
            </a:r>
            <a:endParaRPr sz="1050" dirty="0">
              <a:latin typeface="Arial"/>
              <a:cs typeface="Arial"/>
            </a:endParaRPr>
          </a:p>
          <a:p>
            <a:pPr marL="356870" indent="-220345">
              <a:lnSpc>
                <a:spcPts val="1150"/>
              </a:lnSpc>
              <a:buFont typeface="Arial"/>
              <a:buAutoNum type="arabicPeriod" startAt="10"/>
              <a:tabLst>
                <a:tab pos="356870" algn="l"/>
              </a:tabLst>
            </a:pPr>
            <a:r>
              <a:rPr sz="1050" dirty="0">
                <a:latin typeface="Arial"/>
                <a:cs typeface="Arial"/>
              </a:rPr>
              <a:t>HR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&lt;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60.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What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hould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you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do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efore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CPR?</a:t>
            </a:r>
            <a:endParaRPr sz="1050" dirty="0">
              <a:latin typeface="Arial"/>
              <a:cs typeface="Arial"/>
            </a:endParaRPr>
          </a:p>
          <a:p>
            <a:pPr marL="136525" marR="463550" indent="220345">
              <a:lnSpc>
                <a:spcPts val="1210"/>
              </a:lnSpc>
              <a:spcBef>
                <a:spcPts val="55"/>
              </a:spcBef>
              <a:buFont typeface="Arial"/>
              <a:buAutoNum type="arabicPeriod" startAt="10"/>
              <a:tabLst>
                <a:tab pos="356870" algn="l"/>
              </a:tabLst>
            </a:pPr>
            <a:r>
              <a:rPr sz="1050" dirty="0">
                <a:latin typeface="Arial"/>
                <a:cs typeface="Arial"/>
              </a:rPr>
              <a:t>You</a:t>
            </a:r>
            <a:r>
              <a:rPr sz="1050" spc="20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warmed/dried/stimulated;</a:t>
            </a:r>
            <a:r>
              <a:rPr sz="1050" spc="3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t's</a:t>
            </a:r>
            <a:r>
              <a:rPr sz="1050" spc="3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een</a:t>
            </a:r>
            <a:r>
              <a:rPr sz="1050" spc="30" dirty="0">
                <a:latin typeface="Arial"/>
                <a:cs typeface="Arial"/>
              </a:rPr>
              <a:t> </a:t>
            </a:r>
            <a:r>
              <a:rPr sz="1050" spc="-25" dirty="0">
                <a:latin typeface="Arial"/>
                <a:cs typeface="Arial"/>
              </a:rPr>
              <a:t>60 </a:t>
            </a:r>
            <a:r>
              <a:rPr sz="1050" dirty="0">
                <a:latin typeface="Arial"/>
                <a:cs typeface="Arial"/>
              </a:rPr>
              <a:t>seconds,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he's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til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limp/apneic.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ow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what? (abbreviation)</a:t>
            </a:r>
            <a:endParaRPr sz="1050" dirty="0">
              <a:latin typeface="Arial"/>
              <a:cs typeface="Arial"/>
            </a:endParaRPr>
          </a:p>
          <a:p>
            <a:pPr marL="356870" indent="-220345">
              <a:lnSpc>
                <a:spcPts val="1150"/>
              </a:lnSpc>
              <a:buFont typeface="Arial"/>
              <a:buAutoNum type="arabicPeriod" startAt="10"/>
              <a:tabLst>
                <a:tab pos="356870" algn="l"/>
              </a:tabLst>
            </a:pPr>
            <a:r>
              <a:rPr sz="1050" dirty="0">
                <a:latin typeface="Arial"/>
                <a:cs typeface="Arial"/>
              </a:rPr>
              <a:t>Spell</a:t>
            </a:r>
            <a:r>
              <a:rPr sz="1050" spc="-2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h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rat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f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xygen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flow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L/min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when</a:t>
            </a:r>
            <a:endParaRPr sz="1050" dirty="0">
              <a:latin typeface="Arial"/>
              <a:cs typeface="Arial"/>
            </a:endParaRPr>
          </a:p>
          <a:p>
            <a:pPr marL="136525">
              <a:lnSpc>
                <a:spcPts val="1210"/>
              </a:lnSpc>
            </a:pPr>
            <a:r>
              <a:rPr sz="1050" dirty="0">
                <a:latin typeface="Arial"/>
                <a:cs typeface="Arial"/>
              </a:rPr>
              <a:t>administering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blow-</a:t>
            </a:r>
            <a:r>
              <a:rPr sz="1050" spc="-25" dirty="0">
                <a:latin typeface="Arial"/>
                <a:cs typeface="Arial"/>
              </a:rPr>
              <a:t>by</a:t>
            </a:r>
            <a:endParaRPr sz="1050" dirty="0">
              <a:latin typeface="Arial"/>
              <a:cs typeface="Arial"/>
            </a:endParaRPr>
          </a:p>
          <a:p>
            <a:pPr marL="136525" marR="5080" indent="220345">
              <a:lnSpc>
                <a:spcPts val="1210"/>
              </a:lnSpc>
              <a:spcBef>
                <a:spcPts val="60"/>
              </a:spcBef>
              <a:buFont typeface="Arial"/>
              <a:buAutoNum type="arabicPeriod" startAt="13"/>
              <a:tabLst>
                <a:tab pos="356870" algn="l"/>
                <a:tab pos="1101090" algn="l"/>
              </a:tabLst>
            </a:pPr>
            <a:r>
              <a:rPr sz="1050" dirty="0">
                <a:latin typeface="Arial"/>
                <a:cs typeface="Arial"/>
              </a:rPr>
              <a:t>Your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itia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assessment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hould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clude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erm,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tone, </a:t>
            </a:r>
            <a:r>
              <a:rPr sz="1050" dirty="0">
                <a:latin typeface="Arial"/>
                <a:cs typeface="Arial"/>
              </a:rPr>
              <a:t>breathing, </a:t>
            </a:r>
            <a:r>
              <a:rPr sz="1050" u="sng" dirty="0">
                <a:uFill>
                  <a:solidFill>
                    <a:srgbClr val="000000"/>
                  </a:solidFill>
                </a:uFill>
                <a:latin typeface="Times New Roman"/>
                <a:cs typeface="Times New Roman"/>
              </a:rPr>
              <a:t>	</a:t>
            </a:r>
            <a:endParaRPr sz="1050" dirty="0">
              <a:latin typeface="Times New Roman"/>
              <a:cs typeface="Times New Roman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2745739" y="386588"/>
            <a:ext cx="4595495" cy="58166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2618105">
              <a:lnSpc>
                <a:spcPts val="1215"/>
              </a:lnSpc>
              <a:spcBef>
                <a:spcPts val="105"/>
              </a:spcBef>
              <a:tabLst>
                <a:tab pos="4582160" algn="l"/>
              </a:tabLst>
            </a:pPr>
            <a:r>
              <a:rPr sz="1050" spc="-10" dirty="0">
                <a:latin typeface="Arial"/>
                <a:cs typeface="Arial"/>
              </a:rPr>
              <a:t>Name:</a:t>
            </a:r>
            <a:r>
              <a:rPr sz="1050" u="sng" dirty="0">
                <a:uFill>
                  <a:solidFill>
                    <a:srgbClr val="000000"/>
                  </a:solidFill>
                </a:uFill>
                <a:latin typeface="Times New Roman"/>
                <a:cs typeface="Times New Roman"/>
              </a:rPr>
              <a:t>	</a:t>
            </a:r>
            <a:endParaRPr sz="1050">
              <a:latin typeface="Times New Roman"/>
              <a:cs typeface="Times New Roman"/>
            </a:endParaRPr>
          </a:p>
          <a:p>
            <a:pPr marR="2306955" algn="ctr">
              <a:lnSpc>
                <a:spcPts val="1914"/>
              </a:lnSpc>
            </a:pPr>
            <a:r>
              <a:rPr sz="1650" b="1" dirty="0">
                <a:latin typeface="Arial"/>
                <a:cs typeface="Arial"/>
              </a:rPr>
              <a:t>NRP</a:t>
            </a:r>
            <a:r>
              <a:rPr sz="1650" b="1" spc="-10" dirty="0">
                <a:latin typeface="Arial"/>
                <a:cs typeface="Arial"/>
              </a:rPr>
              <a:t> Crossword</a:t>
            </a:r>
            <a:endParaRPr sz="1650">
              <a:latin typeface="Arial"/>
              <a:cs typeface="Arial"/>
            </a:endParaRPr>
          </a:p>
          <a:p>
            <a:pPr marR="2303780" algn="ctr">
              <a:lnSpc>
                <a:spcPts val="1240"/>
              </a:lnSpc>
            </a:pPr>
            <a:r>
              <a:rPr sz="1050" dirty="0">
                <a:latin typeface="Arial"/>
                <a:cs typeface="Arial"/>
              </a:rPr>
              <a:t>Complete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he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crossword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puzzle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below</a:t>
            </a:r>
            <a:endParaRPr sz="1050">
              <a:latin typeface="Arial"/>
              <a:cs typeface="Arial"/>
            </a:endParaRPr>
          </a:p>
        </p:txBody>
      </p:sp>
      <p:grpSp>
        <p:nvGrpSpPr>
          <p:cNvPr id="4" name="object 4"/>
          <p:cNvGrpSpPr/>
          <p:nvPr/>
        </p:nvGrpSpPr>
        <p:grpSpPr>
          <a:xfrm>
            <a:off x="2076907" y="1045463"/>
            <a:ext cx="3667760" cy="4959985"/>
            <a:chOff x="2076907" y="1045463"/>
            <a:chExt cx="3667760" cy="4959985"/>
          </a:xfrm>
        </p:grpSpPr>
        <p:pic>
          <p:nvPicPr>
            <p:cNvPr id="5" name="object 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44670" y="1045463"/>
              <a:ext cx="307238" cy="307238"/>
            </a:xfrm>
            <a:prstGeom prst="rect">
              <a:avLst/>
            </a:prstGeom>
          </p:spPr>
        </p:pic>
        <p:sp>
          <p:nvSpPr>
            <p:cNvPr id="6" name="object 6"/>
            <p:cNvSpPr/>
            <p:nvPr/>
          </p:nvSpPr>
          <p:spPr>
            <a:xfrm>
              <a:off x="4144670" y="104546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7" name="object 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44670" y="1303934"/>
              <a:ext cx="307238" cy="307238"/>
            </a:xfrm>
            <a:prstGeom prst="rect">
              <a:avLst/>
            </a:prstGeom>
          </p:spPr>
        </p:pic>
        <p:sp>
          <p:nvSpPr>
            <p:cNvPr id="8" name="object 8"/>
            <p:cNvSpPr/>
            <p:nvPr/>
          </p:nvSpPr>
          <p:spPr>
            <a:xfrm>
              <a:off x="4144670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9" name="object 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44670" y="1562404"/>
              <a:ext cx="307238" cy="307238"/>
            </a:xfrm>
            <a:prstGeom prst="rect">
              <a:avLst/>
            </a:prstGeom>
          </p:spPr>
        </p:pic>
        <p:sp>
          <p:nvSpPr>
            <p:cNvPr id="10" name="object 10"/>
            <p:cNvSpPr/>
            <p:nvPr/>
          </p:nvSpPr>
          <p:spPr>
            <a:xfrm>
              <a:off x="4144670" y="156240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1" name="object 1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44670" y="1820875"/>
              <a:ext cx="307238" cy="307238"/>
            </a:xfrm>
            <a:prstGeom prst="rect">
              <a:avLst/>
            </a:prstGeom>
          </p:spPr>
        </p:pic>
        <p:sp>
          <p:nvSpPr>
            <p:cNvPr id="12" name="object 12"/>
            <p:cNvSpPr/>
            <p:nvPr/>
          </p:nvSpPr>
          <p:spPr>
            <a:xfrm>
              <a:off x="4144670" y="182087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3" name="object 1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076907" y="1303934"/>
              <a:ext cx="307238" cy="307238"/>
            </a:xfrm>
            <a:prstGeom prst="rect">
              <a:avLst/>
            </a:prstGeom>
          </p:spPr>
        </p:pic>
        <p:sp>
          <p:nvSpPr>
            <p:cNvPr id="14" name="object 14"/>
            <p:cNvSpPr/>
            <p:nvPr/>
          </p:nvSpPr>
          <p:spPr>
            <a:xfrm>
              <a:off x="2076907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5" name="object 1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335377" y="1303934"/>
              <a:ext cx="307238" cy="307238"/>
            </a:xfrm>
            <a:prstGeom prst="rect">
              <a:avLst/>
            </a:prstGeom>
          </p:spPr>
        </p:pic>
        <p:sp>
          <p:nvSpPr>
            <p:cNvPr id="16" name="object 16"/>
            <p:cNvSpPr/>
            <p:nvPr/>
          </p:nvSpPr>
          <p:spPr>
            <a:xfrm>
              <a:off x="2335377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7" name="object 1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593847" y="1303934"/>
              <a:ext cx="307238" cy="307238"/>
            </a:xfrm>
            <a:prstGeom prst="rect">
              <a:avLst/>
            </a:prstGeom>
          </p:spPr>
        </p:pic>
        <p:sp>
          <p:nvSpPr>
            <p:cNvPr id="18" name="object 18"/>
            <p:cNvSpPr/>
            <p:nvPr/>
          </p:nvSpPr>
          <p:spPr>
            <a:xfrm>
              <a:off x="2593847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9" name="object 1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852318" y="1303934"/>
              <a:ext cx="307238" cy="307238"/>
            </a:xfrm>
            <a:prstGeom prst="rect">
              <a:avLst/>
            </a:prstGeom>
          </p:spPr>
        </p:pic>
        <p:sp>
          <p:nvSpPr>
            <p:cNvPr id="20" name="object 20"/>
            <p:cNvSpPr/>
            <p:nvPr/>
          </p:nvSpPr>
          <p:spPr>
            <a:xfrm>
              <a:off x="2852318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21" name="object 2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110788" y="1303934"/>
              <a:ext cx="307238" cy="307238"/>
            </a:xfrm>
            <a:prstGeom prst="rect">
              <a:avLst/>
            </a:prstGeom>
          </p:spPr>
        </p:pic>
        <p:sp>
          <p:nvSpPr>
            <p:cNvPr id="22" name="object 22"/>
            <p:cNvSpPr/>
            <p:nvPr/>
          </p:nvSpPr>
          <p:spPr>
            <a:xfrm>
              <a:off x="3110788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23" name="object 2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369259" y="1303934"/>
              <a:ext cx="307238" cy="307238"/>
            </a:xfrm>
            <a:prstGeom prst="rect">
              <a:avLst/>
            </a:prstGeom>
          </p:spPr>
        </p:pic>
        <p:sp>
          <p:nvSpPr>
            <p:cNvPr id="24" name="object 24"/>
            <p:cNvSpPr/>
            <p:nvPr/>
          </p:nvSpPr>
          <p:spPr>
            <a:xfrm>
              <a:off x="3369259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25" name="object 2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1303934"/>
              <a:ext cx="307238" cy="307238"/>
            </a:xfrm>
            <a:prstGeom prst="rect">
              <a:avLst/>
            </a:prstGeom>
          </p:spPr>
        </p:pic>
        <p:sp>
          <p:nvSpPr>
            <p:cNvPr id="26" name="object 26"/>
            <p:cNvSpPr/>
            <p:nvPr/>
          </p:nvSpPr>
          <p:spPr>
            <a:xfrm>
              <a:off x="3627729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27" name="object 2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852318" y="1562404"/>
              <a:ext cx="307238" cy="307238"/>
            </a:xfrm>
            <a:prstGeom prst="rect">
              <a:avLst/>
            </a:prstGeom>
          </p:spPr>
        </p:pic>
        <p:sp>
          <p:nvSpPr>
            <p:cNvPr id="28" name="object 28"/>
            <p:cNvSpPr/>
            <p:nvPr/>
          </p:nvSpPr>
          <p:spPr>
            <a:xfrm>
              <a:off x="2852318" y="156240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29" name="object 2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1562404"/>
              <a:ext cx="307238" cy="307238"/>
            </a:xfrm>
            <a:prstGeom prst="rect">
              <a:avLst/>
            </a:prstGeom>
          </p:spPr>
        </p:pic>
        <p:sp>
          <p:nvSpPr>
            <p:cNvPr id="30" name="object 30"/>
            <p:cNvSpPr/>
            <p:nvPr/>
          </p:nvSpPr>
          <p:spPr>
            <a:xfrm>
              <a:off x="3627729" y="156240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1" name="object 3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852318" y="1820875"/>
              <a:ext cx="307238" cy="307238"/>
            </a:xfrm>
            <a:prstGeom prst="rect">
              <a:avLst/>
            </a:prstGeom>
          </p:spPr>
        </p:pic>
        <p:sp>
          <p:nvSpPr>
            <p:cNvPr id="32" name="object 32"/>
            <p:cNvSpPr/>
            <p:nvPr/>
          </p:nvSpPr>
          <p:spPr>
            <a:xfrm>
              <a:off x="2852318" y="182087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3" name="object 3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1820875"/>
              <a:ext cx="307238" cy="307238"/>
            </a:xfrm>
            <a:prstGeom prst="rect">
              <a:avLst/>
            </a:prstGeom>
          </p:spPr>
        </p:pic>
        <p:sp>
          <p:nvSpPr>
            <p:cNvPr id="34" name="object 34"/>
            <p:cNvSpPr/>
            <p:nvPr/>
          </p:nvSpPr>
          <p:spPr>
            <a:xfrm>
              <a:off x="3627729" y="182087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5" name="object 3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852318" y="2079345"/>
              <a:ext cx="307238" cy="307238"/>
            </a:xfrm>
            <a:prstGeom prst="rect">
              <a:avLst/>
            </a:prstGeom>
          </p:spPr>
        </p:pic>
        <p:sp>
          <p:nvSpPr>
            <p:cNvPr id="36" name="object 36"/>
            <p:cNvSpPr/>
            <p:nvPr/>
          </p:nvSpPr>
          <p:spPr>
            <a:xfrm>
              <a:off x="2852318" y="207934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7" name="object 3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369259" y="2079345"/>
              <a:ext cx="307238" cy="307238"/>
            </a:xfrm>
            <a:prstGeom prst="rect">
              <a:avLst/>
            </a:prstGeom>
          </p:spPr>
        </p:pic>
        <p:sp>
          <p:nvSpPr>
            <p:cNvPr id="38" name="object 38"/>
            <p:cNvSpPr/>
            <p:nvPr/>
          </p:nvSpPr>
          <p:spPr>
            <a:xfrm>
              <a:off x="3369259" y="207934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9" name="object 3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2079345"/>
              <a:ext cx="307238" cy="307238"/>
            </a:xfrm>
            <a:prstGeom prst="rect">
              <a:avLst/>
            </a:prstGeom>
          </p:spPr>
        </p:pic>
        <p:sp>
          <p:nvSpPr>
            <p:cNvPr id="40" name="object 40"/>
            <p:cNvSpPr/>
            <p:nvPr/>
          </p:nvSpPr>
          <p:spPr>
            <a:xfrm>
              <a:off x="3627729" y="207934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41" name="object 4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886200" y="2079345"/>
              <a:ext cx="307238" cy="307238"/>
            </a:xfrm>
            <a:prstGeom prst="rect">
              <a:avLst/>
            </a:prstGeom>
          </p:spPr>
        </p:pic>
        <p:sp>
          <p:nvSpPr>
            <p:cNvPr id="42" name="object 42"/>
            <p:cNvSpPr/>
            <p:nvPr/>
          </p:nvSpPr>
          <p:spPr>
            <a:xfrm>
              <a:off x="3886200" y="207934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43" name="object 4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44670" y="2079345"/>
              <a:ext cx="307238" cy="307238"/>
            </a:xfrm>
            <a:prstGeom prst="rect">
              <a:avLst/>
            </a:prstGeom>
          </p:spPr>
        </p:pic>
        <p:sp>
          <p:nvSpPr>
            <p:cNvPr id="44" name="object 44"/>
            <p:cNvSpPr/>
            <p:nvPr/>
          </p:nvSpPr>
          <p:spPr>
            <a:xfrm>
              <a:off x="4144670" y="207934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45" name="object 4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403140" y="2079345"/>
              <a:ext cx="307238" cy="307238"/>
            </a:xfrm>
            <a:prstGeom prst="rect">
              <a:avLst/>
            </a:prstGeom>
          </p:spPr>
        </p:pic>
        <p:sp>
          <p:nvSpPr>
            <p:cNvPr id="46" name="object 46"/>
            <p:cNvSpPr/>
            <p:nvPr/>
          </p:nvSpPr>
          <p:spPr>
            <a:xfrm>
              <a:off x="4403140" y="207934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47" name="object 4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852318" y="2337816"/>
              <a:ext cx="307238" cy="307238"/>
            </a:xfrm>
            <a:prstGeom prst="rect">
              <a:avLst/>
            </a:prstGeom>
          </p:spPr>
        </p:pic>
        <p:sp>
          <p:nvSpPr>
            <p:cNvPr id="48" name="object 48"/>
            <p:cNvSpPr/>
            <p:nvPr/>
          </p:nvSpPr>
          <p:spPr>
            <a:xfrm>
              <a:off x="2852318" y="233781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49" name="object 4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2337816"/>
              <a:ext cx="307238" cy="307238"/>
            </a:xfrm>
            <a:prstGeom prst="rect">
              <a:avLst/>
            </a:prstGeom>
          </p:spPr>
        </p:pic>
        <p:sp>
          <p:nvSpPr>
            <p:cNvPr id="50" name="object 50"/>
            <p:cNvSpPr/>
            <p:nvPr/>
          </p:nvSpPr>
          <p:spPr>
            <a:xfrm>
              <a:off x="3627729" y="233781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51" name="object 5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2596286"/>
              <a:ext cx="307238" cy="307238"/>
            </a:xfrm>
            <a:prstGeom prst="rect">
              <a:avLst/>
            </a:prstGeom>
          </p:spPr>
        </p:pic>
        <p:sp>
          <p:nvSpPr>
            <p:cNvPr id="52" name="object 52"/>
            <p:cNvSpPr/>
            <p:nvPr/>
          </p:nvSpPr>
          <p:spPr>
            <a:xfrm>
              <a:off x="3627729" y="259628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53" name="object 5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886200" y="2596286"/>
              <a:ext cx="307238" cy="307238"/>
            </a:xfrm>
            <a:prstGeom prst="rect">
              <a:avLst/>
            </a:prstGeom>
          </p:spPr>
        </p:pic>
        <p:sp>
          <p:nvSpPr>
            <p:cNvPr id="54" name="object 54"/>
            <p:cNvSpPr/>
            <p:nvPr/>
          </p:nvSpPr>
          <p:spPr>
            <a:xfrm>
              <a:off x="3886200" y="259628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55" name="object 5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44670" y="2596286"/>
              <a:ext cx="307238" cy="307238"/>
            </a:xfrm>
            <a:prstGeom prst="rect">
              <a:avLst/>
            </a:prstGeom>
          </p:spPr>
        </p:pic>
        <p:sp>
          <p:nvSpPr>
            <p:cNvPr id="56" name="object 56"/>
            <p:cNvSpPr/>
            <p:nvPr/>
          </p:nvSpPr>
          <p:spPr>
            <a:xfrm>
              <a:off x="4144670" y="259628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57" name="object 5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403140" y="2596286"/>
              <a:ext cx="307238" cy="307238"/>
            </a:xfrm>
            <a:prstGeom prst="rect">
              <a:avLst/>
            </a:prstGeom>
          </p:spPr>
        </p:pic>
        <p:sp>
          <p:nvSpPr>
            <p:cNvPr id="58" name="object 58"/>
            <p:cNvSpPr/>
            <p:nvPr/>
          </p:nvSpPr>
          <p:spPr>
            <a:xfrm>
              <a:off x="4403140" y="259628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59" name="object 5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661611" y="2596286"/>
              <a:ext cx="307238" cy="307238"/>
            </a:xfrm>
            <a:prstGeom prst="rect">
              <a:avLst/>
            </a:prstGeom>
          </p:spPr>
        </p:pic>
        <p:sp>
          <p:nvSpPr>
            <p:cNvPr id="60" name="object 60"/>
            <p:cNvSpPr/>
            <p:nvPr/>
          </p:nvSpPr>
          <p:spPr>
            <a:xfrm>
              <a:off x="4661611" y="259628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61" name="object 6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920081" y="2596286"/>
              <a:ext cx="307238" cy="307238"/>
            </a:xfrm>
            <a:prstGeom prst="rect">
              <a:avLst/>
            </a:prstGeom>
          </p:spPr>
        </p:pic>
        <p:sp>
          <p:nvSpPr>
            <p:cNvPr id="62" name="object 62"/>
            <p:cNvSpPr/>
            <p:nvPr/>
          </p:nvSpPr>
          <p:spPr>
            <a:xfrm>
              <a:off x="4920081" y="259628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63" name="object 6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2854756"/>
              <a:ext cx="307238" cy="307238"/>
            </a:xfrm>
            <a:prstGeom prst="rect">
              <a:avLst/>
            </a:prstGeom>
          </p:spPr>
        </p:pic>
        <p:sp>
          <p:nvSpPr>
            <p:cNvPr id="64" name="object 64"/>
            <p:cNvSpPr/>
            <p:nvPr/>
          </p:nvSpPr>
          <p:spPr>
            <a:xfrm>
              <a:off x="3627729" y="285475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65" name="object 6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3113227"/>
              <a:ext cx="307238" cy="307238"/>
            </a:xfrm>
            <a:prstGeom prst="rect">
              <a:avLst/>
            </a:prstGeom>
          </p:spPr>
        </p:pic>
        <p:sp>
          <p:nvSpPr>
            <p:cNvPr id="66" name="object 66"/>
            <p:cNvSpPr/>
            <p:nvPr/>
          </p:nvSpPr>
          <p:spPr>
            <a:xfrm>
              <a:off x="3627729" y="3113227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67" name="object 6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3371697"/>
              <a:ext cx="307238" cy="307238"/>
            </a:xfrm>
            <a:prstGeom prst="rect">
              <a:avLst/>
            </a:prstGeom>
          </p:spPr>
        </p:pic>
        <p:sp>
          <p:nvSpPr>
            <p:cNvPr id="68" name="object 68"/>
            <p:cNvSpPr/>
            <p:nvPr/>
          </p:nvSpPr>
          <p:spPr>
            <a:xfrm>
              <a:off x="3627729" y="3371697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69" name="object 6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44670" y="3371697"/>
              <a:ext cx="307238" cy="307238"/>
            </a:xfrm>
            <a:prstGeom prst="rect">
              <a:avLst/>
            </a:prstGeom>
          </p:spPr>
        </p:pic>
        <p:sp>
          <p:nvSpPr>
            <p:cNvPr id="70" name="object 70"/>
            <p:cNvSpPr/>
            <p:nvPr/>
          </p:nvSpPr>
          <p:spPr>
            <a:xfrm>
              <a:off x="4144670" y="3371697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71" name="object 7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3630168"/>
              <a:ext cx="307238" cy="307238"/>
            </a:xfrm>
            <a:prstGeom prst="rect">
              <a:avLst/>
            </a:prstGeom>
          </p:spPr>
        </p:pic>
        <p:sp>
          <p:nvSpPr>
            <p:cNvPr id="72" name="object 72"/>
            <p:cNvSpPr/>
            <p:nvPr/>
          </p:nvSpPr>
          <p:spPr>
            <a:xfrm>
              <a:off x="3627729" y="363016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73" name="object 7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44670" y="3630168"/>
              <a:ext cx="307238" cy="307238"/>
            </a:xfrm>
            <a:prstGeom prst="rect">
              <a:avLst/>
            </a:prstGeom>
          </p:spPr>
        </p:pic>
        <p:sp>
          <p:nvSpPr>
            <p:cNvPr id="74" name="object 74"/>
            <p:cNvSpPr/>
            <p:nvPr/>
          </p:nvSpPr>
          <p:spPr>
            <a:xfrm>
              <a:off x="4144670" y="363016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75" name="object 7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3888638"/>
              <a:ext cx="307238" cy="307238"/>
            </a:xfrm>
            <a:prstGeom prst="rect">
              <a:avLst/>
            </a:prstGeom>
          </p:spPr>
        </p:pic>
        <p:sp>
          <p:nvSpPr>
            <p:cNvPr id="76" name="object 76"/>
            <p:cNvSpPr/>
            <p:nvPr/>
          </p:nvSpPr>
          <p:spPr>
            <a:xfrm>
              <a:off x="3627729" y="388863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77" name="object 7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44670" y="3888638"/>
              <a:ext cx="307238" cy="307238"/>
            </a:xfrm>
            <a:prstGeom prst="rect">
              <a:avLst/>
            </a:prstGeom>
          </p:spPr>
        </p:pic>
        <p:sp>
          <p:nvSpPr>
            <p:cNvPr id="78" name="object 78"/>
            <p:cNvSpPr/>
            <p:nvPr/>
          </p:nvSpPr>
          <p:spPr>
            <a:xfrm>
              <a:off x="4144670" y="388863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79" name="object 7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920081" y="3888638"/>
              <a:ext cx="307238" cy="307238"/>
            </a:xfrm>
            <a:prstGeom prst="rect">
              <a:avLst/>
            </a:prstGeom>
          </p:spPr>
        </p:pic>
        <p:sp>
          <p:nvSpPr>
            <p:cNvPr id="80" name="object 80"/>
            <p:cNvSpPr/>
            <p:nvPr/>
          </p:nvSpPr>
          <p:spPr>
            <a:xfrm>
              <a:off x="4920081" y="388863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81" name="object 8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4147108"/>
              <a:ext cx="307238" cy="307238"/>
            </a:xfrm>
            <a:prstGeom prst="rect">
              <a:avLst/>
            </a:prstGeom>
          </p:spPr>
        </p:pic>
        <p:sp>
          <p:nvSpPr>
            <p:cNvPr id="82" name="object 82"/>
            <p:cNvSpPr/>
            <p:nvPr/>
          </p:nvSpPr>
          <p:spPr>
            <a:xfrm>
              <a:off x="3627729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83" name="object 8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886200" y="4147108"/>
              <a:ext cx="307238" cy="307238"/>
            </a:xfrm>
            <a:prstGeom prst="rect">
              <a:avLst/>
            </a:prstGeom>
          </p:spPr>
        </p:pic>
        <p:sp>
          <p:nvSpPr>
            <p:cNvPr id="84" name="object 84"/>
            <p:cNvSpPr/>
            <p:nvPr/>
          </p:nvSpPr>
          <p:spPr>
            <a:xfrm>
              <a:off x="3886200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85" name="object 8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44670" y="4147108"/>
              <a:ext cx="307238" cy="307238"/>
            </a:xfrm>
            <a:prstGeom prst="rect">
              <a:avLst/>
            </a:prstGeom>
          </p:spPr>
        </p:pic>
        <p:sp>
          <p:nvSpPr>
            <p:cNvPr id="86" name="object 86"/>
            <p:cNvSpPr/>
            <p:nvPr/>
          </p:nvSpPr>
          <p:spPr>
            <a:xfrm>
              <a:off x="4144670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87" name="object 8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403140" y="4147108"/>
              <a:ext cx="307238" cy="307238"/>
            </a:xfrm>
            <a:prstGeom prst="rect">
              <a:avLst/>
            </a:prstGeom>
          </p:spPr>
        </p:pic>
        <p:sp>
          <p:nvSpPr>
            <p:cNvPr id="88" name="object 88"/>
            <p:cNvSpPr/>
            <p:nvPr/>
          </p:nvSpPr>
          <p:spPr>
            <a:xfrm>
              <a:off x="4403140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89" name="object 8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661611" y="4147108"/>
              <a:ext cx="307238" cy="307238"/>
            </a:xfrm>
            <a:prstGeom prst="rect">
              <a:avLst/>
            </a:prstGeom>
          </p:spPr>
        </p:pic>
        <p:sp>
          <p:nvSpPr>
            <p:cNvPr id="90" name="object 90"/>
            <p:cNvSpPr/>
            <p:nvPr/>
          </p:nvSpPr>
          <p:spPr>
            <a:xfrm>
              <a:off x="4661611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91" name="object 9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920081" y="4147108"/>
              <a:ext cx="307238" cy="307238"/>
            </a:xfrm>
            <a:prstGeom prst="rect">
              <a:avLst/>
            </a:prstGeom>
          </p:spPr>
        </p:pic>
        <p:sp>
          <p:nvSpPr>
            <p:cNvPr id="92" name="object 92"/>
            <p:cNvSpPr/>
            <p:nvPr/>
          </p:nvSpPr>
          <p:spPr>
            <a:xfrm>
              <a:off x="4920081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93" name="object 9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5437022" y="3371697"/>
              <a:ext cx="307238" cy="307238"/>
            </a:xfrm>
            <a:prstGeom prst="rect">
              <a:avLst/>
            </a:prstGeom>
          </p:spPr>
        </p:pic>
        <p:sp>
          <p:nvSpPr>
            <p:cNvPr id="94" name="object 94"/>
            <p:cNvSpPr/>
            <p:nvPr/>
          </p:nvSpPr>
          <p:spPr>
            <a:xfrm>
              <a:off x="5437022" y="3371697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95" name="object 9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5437022" y="3630168"/>
              <a:ext cx="307238" cy="307238"/>
            </a:xfrm>
            <a:prstGeom prst="rect">
              <a:avLst/>
            </a:prstGeom>
          </p:spPr>
        </p:pic>
        <p:sp>
          <p:nvSpPr>
            <p:cNvPr id="96" name="object 96"/>
            <p:cNvSpPr/>
            <p:nvPr/>
          </p:nvSpPr>
          <p:spPr>
            <a:xfrm>
              <a:off x="5437022" y="363016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97" name="object 9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5437022" y="3888638"/>
              <a:ext cx="307238" cy="307238"/>
            </a:xfrm>
            <a:prstGeom prst="rect">
              <a:avLst/>
            </a:prstGeom>
          </p:spPr>
        </p:pic>
        <p:sp>
          <p:nvSpPr>
            <p:cNvPr id="98" name="object 98"/>
            <p:cNvSpPr/>
            <p:nvPr/>
          </p:nvSpPr>
          <p:spPr>
            <a:xfrm>
              <a:off x="5437022" y="388863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99" name="object 9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5178551" y="4147108"/>
              <a:ext cx="307238" cy="307238"/>
            </a:xfrm>
            <a:prstGeom prst="rect">
              <a:avLst/>
            </a:prstGeom>
          </p:spPr>
        </p:pic>
        <p:sp>
          <p:nvSpPr>
            <p:cNvPr id="100" name="object 100"/>
            <p:cNvSpPr/>
            <p:nvPr/>
          </p:nvSpPr>
          <p:spPr>
            <a:xfrm>
              <a:off x="5178551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01" name="object 10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5437022" y="4147108"/>
              <a:ext cx="307238" cy="307238"/>
            </a:xfrm>
            <a:prstGeom prst="rect">
              <a:avLst/>
            </a:prstGeom>
          </p:spPr>
        </p:pic>
        <p:sp>
          <p:nvSpPr>
            <p:cNvPr id="102" name="object 102"/>
            <p:cNvSpPr/>
            <p:nvPr/>
          </p:nvSpPr>
          <p:spPr>
            <a:xfrm>
              <a:off x="5437022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03" name="object 10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4405579"/>
              <a:ext cx="307238" cy="307238"/>
            </a:xfrm>
            <a:prstGeom prst="rect">
              <a:avLst/>
            </a:prstGeom>
          </p:spPr>
        </p:pic>
        <p:sp>
          <p:nvSpPr>
            <p:cNvPr id="104" name="object 104"/>
            <p:cNvSpPr/>
            <p:nvPr/>
          </p:nvSpPr>
          <p:spPr>
            <a:xfrm>
              <a:off x="3627729" y="440557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05" name="object 10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44670" y="4405579"/>
              <a:ext cx="307238" cy="307238"/>
            </a:xfrm>
            <a:prstGeom prst="rect">
              <a:avLst/>
            </a:prstGeom>
          </p:spPr>
        </p:pic>
        <p:sp>
          <p:nvSpPr>
            <p:cNvPr id="106" name="object 106"/>
            <p:cNvSpPr/>
            <p:nvPr/>
          </p:nvSpPr>
          <p:spPr>
            <a:xfrm>
              <a:off x="4144670" y="440557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07" name="object 10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920081" y="4405579"/>
              <a:ext cx="307238" cy="307238"/>
            </a:xfrm>
            <a:prstGeom prst="rect">
              <a:avLst/>
            </a:prstGeom>
          </p:spPr>
        </p:pic>
        <p:sp>
          <p:nvSpPr>
            <p:cNvPr id="108" name="object 108"/>
            <p:cNvSpPr/>
            <p:nvPr/>
          </p:nvSpPr>
          <p:spPr>
            <a:xfrm>
              <a:off x="4920081" y="440557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09" name="object 10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4664049"/>
              <a:ext cx="307238" cy="307238"/>
            </a:xfrm>
            <a:prstGeom prst="rect">
              <a:avLst/>
            </a:prstGeom>
          </p:spPr>
        </p:pic>
        <p:sp>
          <p:nvSpPr>
            <p:cNvPr id="110" name="object 110"/>
            <p:cNvSpPr/>
            <p:nvPr/>
          </p:nvSpPr>
          <p:spPr>
            <a:xfrm>
              <a:off x="3627729" y="466404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11" name="object 11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920081" y="4664049"/>
              <a:ext cx="307238" cy="307238"/>
            </a:xfrm>
            <a:prstGeom prst="rect">
              <a:avLst/>
            </a:prstGeom>
          </p:spPr>
        </p:pic>
        <p:sp>
          <p:nvSpPr>
            <p:cNvPr id="112" name="object 112"/>
            <p:cNvSpPr/>
            <p:nvPr/>
          </p:nvSpPr>
          <p:spPr>
            <a:xfrm>
              <a:off x="4920081" y="466404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13" name="object 11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5178551" y="4664049"/>
              <a:ext cx="307238" cy="307238"/>
            </a:xfrm>
            <a:prstGeom prst="rect">
              <a:avLst/>
            </a:prstGeom>
          </p:spPr>
        </p:pic>
        <p:sp>
          <p:nvSpPr>
            <p:cNvPr id="114" name="object 114"/>
            <p:cNvSpPr/>
            <p:nvPr/>
          </p:nvSpPr>
          <p:spPr>
            <a:xfrm>
              <a:off x="5178551" y="466404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15" name="object 11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5437022" y="4664049"/>
              <a:ext cx="307238" cy="307238"/>
            </a:xfrm>
            <a:prstGeom prst="rect">
              <a:avLst/>
            </a:prstGeom>
          </p:spPr>
        </p:pic>
        <p:sp>
          <p:nvSpPr>
            <p:cNvPr id="116" name="object 116"/>
            <p:cNvSpPr/>
            <p:nvPr/>
          </p:nvSpPr>
          <p:spPr>
            <a:xfrm>
              <a:off x="5437022" y="466404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17" name="object 11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4922519"/>
              <a:ext cx="307238" cy="307238"/>
            </a:xfrm>
            <a:prstGeom prst="rect">
              <a:avLst/>
            </a:prstGeom>
          </p:spPr>
        </p:pic>
        <p:sp>
          <p:nvSpPr>
            <p:cNvPr id="118" name="object 118"/>
            <p:cNvSpPr/>
            <p:nvPr/>
          </p:nvSpPr>
          <p:spPr>
            <a:xfrm>
              <a:off x="3627729" y="492251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19" name="object 11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920081" y="4922519"/>
              <a:ext cx="307238" cy="307238"/>
            </a:xfrm>
            <a:prstGeom prst="rect">
              <a:avLst/>
            </a:prstGeom>
          </p:spPr>
        </p:pic>
        <p:sp>
          <p:nvSpPr>
            <p:cNvPr id="120" name="object 120"/>
            <p:cNvSpPr/>
            <p:nvPr/>
          </p:nvSpPr>
          <p:spPr>
            <a:xfrm>
              <a:off x="4920081" y="492251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21" name="object 12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5180990"/>
              <a:ext cx="307238" cy="307238"/>
            </a:xfrm>
            <a:prstGeom prst="rect">
              <a:avLst/>
            </a:prstGeom>
          </p:spPr>
        </p:pic>
        <p:sp>
          <p:nvSpPr>
            <p:cNvPr id="122" name="object 122"/>
            <p:cNvSpPr/>
            <p:nvPr/>
          </p:nvSpPr>
          <p:spPr>
            <a:xfrm>
              <a:off x="3627729" y="5180990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23" name="object 12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403140" y="5180990"/>
              <a:ext cx="307238" cy="307238"/>
            </a:xfrm>
            <a:prstGeom prst="rect">
              <a:avLst/>
            </a:prstGeom>
          </p:spPr>
        </p:pic>
        <p:sp>
          <p:nvSpPr>
            <p:cNvPr id="124" name="object 124"/>
            <p:cNvSpPr/>
            <p:nvPr/>
          </p:nvSpPr>
          <p:spPr>
            <a:xfrm>
              <a:off x="4403140" y="5180990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25" name="object 12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661611" y="5180990"/>
              <a:ext cx="307238" cy="307238"/>
            </a:xfrm>
            <a:prstGeom prst="rect">
              <a:avLst/>
            </a:prstGeom>
          </p:spPr>
        </p:pic>
        <p:sp>
          <p:nvSpPr>
            <p:cNvPr id="126" name="object 126"/>
            <p:cNvSpPr/>
            <p:nvPr/>
          </p:nvSpPr>
          <p:spPr>
            <a:xfrm>
              <a:off x="4661611" y="5180990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27" name="object 12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920081" y="5180990"/>
              <a:ext cx="307238" cy="307238"/>
            </a:xfrm>
            <a:prstGeom prst="rect">
              <a:avLst/>
            </a:prstGeom>
          </p:spPr>
        </p:pic>
        <p:sp>
          <p:nvSpPr>
            <p:cNvPr id="128" name="object 128"/>
            <p:cNvSpPr/>
            <p:nvPr/>
          </p:nvSpPr>
          <p:spPr>
            <a:xfrm>
              <a:off x="4920081" y="5180990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29" name="object 12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5439460"/>
              <a:ext cx="307238" cy="307238"/>
            </a:xfrm>
            <a:prstGeom prst="rect">
              <a:avLst/>
            </a:prstGeom>
          </p:spPr>
        </p:pic>
        <p:sp>
          <p:nvSpPr>
            <p:cNvPr id="130" name="object 130"/>
            <p:cNvSpPr/>
            <p:nvPr/>
          </p:nvSpPr>
          <p:spPr>
            <a:xfrm>
              <a:off x="3627729" y="5439460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31" name="object 13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920081" y="5439460"/>
              <a:ext cx="307238" cy="307238"/>
            </a:xfrm>
            <a:prstGeom prst="rect">
              <a:avLst/>
            </a:prstGeom>
          </p:spPr>
        </p:pic>
        <p:sp>
          <p:nvSpPr>
            <p:cNvPr id="132" name="object 132"/>
            <p:cNvSpPr/>
            <p:nvPr/>
          </p:nvSpPr>
          <p:spPr>
            <a:xfrm>
              <a:off x="4920081" y="5439460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33" name="object 13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369259" y="5697931"/>
              <a:ext cx="307238" cy="307238"/>
            </a:xfrm>
            <a:prstGeom prst="rect">
              <a:avLst/>
            </a:prstGeom>
          </p:spPr>
        </p:pic>
        <p:sp>
          <p:nvSpPr>
            <p:cNvPr id="134" name="object 134"/>
            <p:cNvSpPr/>
            <p:nvPr/>
          </p:nvSpPr>
          <p:spPr>
            <a:xfrm>
              <a:off x="3369259" y="5697931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35" name="object 13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627729" y="5697931"/>
              <a:ext cx="307238" cy="307238"/>
            </a:xfrm>
            <a:prstGeom prst="rect">
              <a:avLst/>
            </a:prstGeom>
          </p:spPr>
        </p:pic>
        <p:sp>
          <p:nvSpPr>
            <p:cNvPr id="136" name="object 136"/>
            <p:cNvSpPr/>
            <p:nvPr/>
          </p:nvSpPr>
          <p:spPr>
            <a:xfrm>
              <a:off x="3627729" y="5697931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37" name="object 13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886200" y="5697931"/>
              <a:ext cx="307238" cy="307238"/>
            </a:xfrm>
            <a:prstGeom prst="rect">
              <a:avLst/>
            </a:prstGeom>
          </p:spPr>
        </p:pic>
        <p:sp>
          <p:nvSpPr>
            <p:cNvPr id="138" name="object 138"/>
            <p:cNvSpPr/>
            <p:nvPr/>
          </p:nvSpPr>
          <p:spPr>
            <a:xfrm>
              <a:off x="3886200" y="5697931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39" name="object 13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44670" y="5697931"/>
              <a:ext cx="307238" cy="307238"/>
            </a:xfrm>
            <a:prstGeom prst="rect">
              <a:avLst/>
            </a:prstGeom>
          </p:spPr>
        </p:pic>
        <p:sp>
          <p:nvSpPr>
            <p:cNvPr id="140" name="object 140"/>
            <p:cNvSpPr/>
            <p:nvPr/>
          </p:nvSpPr>
          <p:spPr>
            <a:xfrm>
              <a:off x="4144670" y="5697931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41" name="object 14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403140" y="5697931"/>
              <a:ext cx="307238" cy="307238"/>
            </a:xfrm>
            <a:prstGeom prst="rect">
              <a:avLst/>
            </a:prstGeom>
          </p:spPr>
        </p:pic>
        <p:sp>
          <p:nvSpPr>
            <p:cNvPr id="142" name="object 142"/>
            <p:cNvSpPr/>
            <p:nvPr/>
          </p:nvSpPr>
          <p:spPr>
            <a:xfrm>
              <a:off x="4403140" y="5697931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43" name="object 14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661611" y="5697931"/>
              <a:ext cx="307238" cy="307238"/>
            </a:xfrm>
            <a:prstGeom prst="rect">
              <a:avLst/>
            </a:prstGeom>
          </p:spPr>
        </p:pic>
        <p:sp>
          <p:nvSpPr>
            <p:cNvPr id="144" name="object 144"/>
            <p:cNvSpPr/>
            <p:nvPr/>
          </p:nvSpPr>
          <p:spPr>
            <a:xfrm>
              <a:off x="4661611" y="5697931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5" name="object 145"/>
            <p:cNvSpPr/>
            <p:nvPr/>
          </p:nvSpPr>
          <p:spPr>
            <a:xfrm>
              <a:off x="2332926" y="1301495"/>
              <a:ext cx="2329180" cy="782955"/>
            </a:xfrm>
            <a:custGeom>
              <a:avLst/>
              <a:gdLst/>
              <a:ahLst/>
              <a:cxnLst/>
              <a:rect l="l" t="t" r="r" b="b"/>
              <a:pathLst>
                <a:path w="2329179" h="782955">
                  <a:moveTo>
                    <a:pt x="2328672" y="775411"/>
                  </a:moveTo>
                  <a:lnTo>
                    <a:pt x="2075078" y="775411"/>
                  </a:lnTo>
                  <a:lnTo>
                    <a:pt x="2075078" y="524256"/>
                  </a:lnTo>
                  <a:lnTo>
                    <a:pt x="2075078" y="519379"/>
                  </a:lnTo>
                  <a:lnTo>
                    <a:pt x="2075078" y="0"/>
                  </a:lnTo>
                  <a:lnTo>
                    <a:pt x="2067763" y="0"/>
                  </a:lnTo>
                  <a:lnTo>
                    <a:pt x="2067763" y="775411"/>
                  </a:lnTo>
                  <a:lnTo>
                    <a:pt x="1816608" y="775411"/>
                  </a:lnTo>
                  <a:lnTo>
                    <a:pt x="1816608" y="524256"/>
                  </a:lnTo>
                  <a:lnTo>
                    <a:pt x="2067763" y="524256"/>
                  </a:lnTo>
                  <a:lnTo>
                    <a:pt x="2067763" y="516940"/>
                  </a:lnTo>
                  <a:lnTo>
                    <a:pt x="1816608" y="516940"/>
                  </a:lnTo>
                  <a:lnTo>
                    <a:pt x="1816608" y="265785"/>
                  </a:lnTo>
                  <a:lnTo>
                    <a:pt x="2067763" y="265785"/>
                  </a:lnTo>
                  <a:lnTo>
                    <a:pt x="2067763" y="258470"/>
                  </a:lnTo>
                  <a:lnTo>
                    <a:pt x="1816608" y="258470"/>
                  </a:lnTo>
                  <a:lnTo>
                    <a:pt x="1816608" y="7315"/>
                  </a:lnTo>
                  <a:lnTo>
                    <a:pt x="2067763" y="7315"/>
                  </a:lnTo>
                  <a:lnTo>
                    <a:pt x="2067763" y="0"/>
                  </a:lnTo>
                  <a:lnTo>
                    <a:pt x="1816608" y="0"/>
                  </a:lnTo>
                  <a:lnTo>
                    <a:pt x="1809292" y="0"/>
                  </a:lnTo>
                  <a:lnTo>
                    <a:pt x="1809292" y="2438"/>
                  </a:lnTo>
                  <a:lnTo>
                    <a:pt x="1809292" y="775411"/>
                  </a:lnTo>
                  <a:lnTo>
                    <a:pt x="1558137" y="775411"/>
                  </a:lnTo>
                  <a:lnTo>
                    <a:pt x="1558137" y="258470"/>
                  </a:lnTo>
                  <a:lnTo>
                    <a:pt x="1550822" y="258470"/>
                  </a:lnTo>
                  <a:lnTo>
                    <a:pt x="1550822" y="265785"/>
                  </a:lnTo>
                  <a:lnTo>
                    <a:pt x="1550822" y="516940"/>
                  </a:lnTo>
                  <a:lnTo>
                    <a:pt x="1550822" y="524256"/>
                  </a:lnTo>
                  <a:lnTo>
                    <a:pt x="1550822" y="775411"/>
                  </a:lnTo>
                  <a:lnTo>
                    <a:pt x="1299667" y="775411"/>
                  </a:lnTo>
                  <a:lnTo>
                    <a:pt x="1299667" y="524256"/>
                  </a:lnTo>
                  <a:lnTo>
                    <a:pt x="1550822" y="524256"/>
                  </a:lnTo>
                  <a:lnTo>
                    <a:pt x="1550822" y="516940"/>
                  </a:lnTo>
                  <a:lnTo>
                    <a:pt x="1299667" y="516940"/>
                  </a:lnTo>
                  <a:lnTo>
                    <a:pt x="1299667" y="265785"/>
                  </a:lnTo>
                  <a:lnTo>
                    <a:pt x="1550822" y="265785"/>
                  </a:lnTo>
                  <a:lnTo>
                    <a:pt x="1550822" y="258470"/>
                  </a:lnTo>
                  <a:lnTo>
                    <a:pt x="1299667" y="258470"/>
                  </a:lnTo>
                  <a:lnTo>
                    <a:pt x="1292352" y="258470"/>
                  </a:lnTo>
                  <a:lnTo>
                    <a:pt x="1041196" y="258470"/>
                  </a:lnTo>
                  <a:lnTo>
                    <a:pt x="1041196" y="7315"/>
                  </a:lnTo>
                  <a:lnTo>
                    <a:pt x="1294790" y="7315"/>
                  </a:lnTo>
                  <a:lnTo>
                    <a:pt x="1299667" y="7315"/>
                  </a:lnTo>
                  <a:lnTo>
                    <a:pt x="1299667" y="0"/>
                  </a:lnTo>
                  <a:lnTo>
                    <a:pt x="1294790" y="0"/>
                  </a:lnTo>
                  <a:lnTo>
                    <a:pt x="1041196" y="0"/>
                  </a:lnTo>
                  <a:lnTo>
                    <a:pt x="1036320" y="0"/>
                  </a:lnTo>
                  <a:lnTo>
                    <a:pt x="1033881" y="0"/>
                  </a:lnTo>
                  <a:lnTo>
                    <a:pt x="1033881" y="7315"/>
                  </a:lnTo>
                  <a:lnTo>
                    <a:pt x="1033881" y="258470"/>
                  </a:lnTo>
                  <a:lnTo>
                    <a:pt x="782726" y="258470"/>
                  </a:lnTo>
                  <a:lnTo>
                    <a:pt x="782726" y="7315"/>
                  </a:lnTo>
                  <a:lnTo>
                    <a:pt x="1033881" y="7315"/>
                  </a:lnTo>
                  <a:lnTo>
                    <a:pt x="1033881" y="0"/>
                  </a:lnTo>
                  <a:lnTo>
                    <a:pt x="782726" y="0"/>
                  </a:lnTo>
                  <a:lnTo>
                    <a:pt x="777849" y="0"/>
                  </a:lnTo>
                  <a:lnTo>
                    <a:pt x="775411" y="0"/>
                  </a:lnTo>
                  <a:lnTo>
                    <a:pt x="775411" y="7315"/>
                  </a:lnTo>
                  <a:lnTo>
                    <a:pt x="775411" y="775411"/>
                  </a:lnTo>
                  <a:lnTo>
                    <a:pt x="524256" y="775411"/>
                  </a:lnTo>
                  <a:lnTo>
                    <a:pt x="524256" y="524256"/>
                  </a:lnTo>
                  <a:lnTo>
                    <a:pt x="775411" y="524256"/>
                  </a:lnTo>
                  <a:lnTo>
                    <a:pt x="775411" y="516940"/>
                  </a:lnTo>
                  <a:lnTo>
                    <a:pt x="524256" y="516940"/>
                  </a:lnTo>
                  <a:lnTo>
                    <a:pt x="524256" y="265785"/>
                  </a:lnTo>
                  <a:lnTo>
                    <a:pt x="775411" y="265785"/>
                  </a:lnTo>
                  <a:lnTo>
                    <a:pt x="775411" y="258470"/>
                  </a:lnTo>
                  <a:lnTo>
                    <a:pt x="524256" y="258470"/>
                  </a:lnTo>
                  <a:lnTo>
                    <a:pt x="516940" y="258470"/>
                  </a:lnTo>
                  <a:lnTo>
                    <a:pt x="265785" y="258470"/>
                  </a:lnTo>
                  <a:lnTo>
                    <a:pt x="265785" y="7315"/>
                  </a:lnTo>
                  <a:lnTo>
                    <a:pt x="519379" y="7315"/>
                  </a:lnTo>
                  <a:lnTo>
                    <a:pt x="524256" y="7315"/>
                  </a:lnTo>
                  <a:lnTo>
                    <a:pt x="524256" y="0"/>
                  </a:lnTo>
                  <a:lnTo>
                    <a:pt x="519379" y="0"/>
                  </a:lnTo>
                  <a:lnTo>
                    <a:pt x="265785" y="0"/>
                  </a:lnTo>
                  <a:lnTo>
                    <a:pt x="260908" y="0"/>
                  </a:lnTo>
                  <a:lnTo>
                    <a:pt x="258470" y="0"/>
                  </a:lnTo>
                  <a:lnTo>
                    <a:pt x="258470" y="7315"/>
                  </a:lnTo>
                  <a:lnTo>
                    <a:pt x="258470" y="258470"/>
                  </a:lnTo>
                  <a:lnTo>
                    <a:pt x="7315" y="258470"/>
                  </a:lnTo>
                  <a:lnTo>
                    <a:pt x="7315" y="7315"/>
                  </a:lnTo>
                  <a:lnTo>
                    <a:pt x="258470" y="7315"/>
                  </a:lnTo>
                  <a:lnTo>
                    <a:pt x="258470" y="0"/>
                  </a:lnTo>
                  <a:lnTo>
                    <a:pt x="7315" y="0"/>
                  </a:lnTo>
                  <a:lnTo>
                    <a:pt x="2438" y="0"/>
                  </a:lnTo>
                  <a:lnTo>
                    <a:pt x="0" y="0"/>
                  </a:lnTo>
                  <a:lnTo>
                    <a:pt x="0" y="7315"/>
                  </a:lnTo>
                  <a:lnTo>
                    <a:pt x="0" y="258470"/>
                  </a:lnTo>
                  <a:lnTo>
                    <a:pt x="0" y="265785"/>
                  </a:lnTo>
                  <a:lnTo>
                    <a:pt x="2438" y="265785"/>
                  </a:lnTo>
                  <a:lnTo>
                    <a:pt x="516940" y="265785"/>
                  </a:lnTo>
                  <a:lnTo>
                    <a:pt x="516940" y="516940"/>
                  </a:lnTo>
                  <a:lnTo>
                    <a:pt x="516940" y="782726"/>
                  </a:lnTo>
                  <a:lnTo>
                    <a:pt x="524256" y="782726"/>
                  </a:lnTo>
                  <a:lnTo>
                    <a:pt x="775411" y="782726"/>
                  </a:lnTo>
                  <a:lnTo>
                    <a:pt x="782726" y="782726"/>
                  </a:lnTo>
                  <a:lnTo>
                    <a:pt x="782726" y="777849"/>
                  </a:lnTo>
                  <a:lnTo>
                    <a:pt x="782726" y="265785"/>
                  </a:lnTo>
                  <a:lnTo>
                    <a:pt x="1033881" y="265785"/>
                  </a:lnTo>
                  <a:lnTo>
                    <a:pt x="1036320" y="265785"/>
                  </a:lnTo>
                  <a:lnTo>
                    <a:pt x="1041196" y="265785"/>
                  </a:lnTo>
                  <a:lnTo>
                    <a:pt x="1292352" y="265785"/>
                  </a:lnTo>
                  <a:lnTo>
                    <a:pt x="1292352" y="516940"/>
                  </a:lnTo>
                  <a:lnTo>
                    <a:pt x="1292352" y="519379"/>
                  </a:lnTo>
                  <a:lnTo>
                    <a:pt x="1292352" y="524256"/>
                  </a:lnTo>
                  <a:lnTo>
                    <a:pt x="1292352" y="775411"/>
                  </a:lnTo>
                  <a:lnTo>
                    <a:pt x="1292352" y="782726"/>
                  </a:lnTo>
                  <a:lnTo>
                    <a:pt x="1299667" y="782726"/>
                  </a:lnTo>
                  <a:lnTo>
                    <a:pt x="2328672" y="782726"/>
                  </a:lnTo>
                  <a:lnTo>
                    <a:pt x="2328672" y="775411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6" name="object 146"/>
            <p:cNvSpPr/>
            <p:nvPr/>
          </p:nvSpPr>
          <p:spPr>
            <a:xfrm>
              <a:off x="2849867" y="1820874"/>
              <a:ext cx="2333625" cy="1297305"/>
            </a:xfrm>
            <a:custGeom>
              <a:avLst/>
              <a:gdLst/>
              <a:ahLst/>
              <a:cxnLst/>
              <a:rect l="l" t="t" r="r" b="b"/>
              <a:pathLst>
                <a:path w="2333625" h="1297305">
                  <a:moveTo>
                    <a:pt x="265785" y="256032"/>
                  </a:moveTo>
                  <a:lnTo>
                    <a:pt x="258470" y="256032"/>
                  </a:lnTo>
                  <a:lnTo>
                    <a:pt x="258470" y="263347"/>
                  </a:lnTo>
                  <a:lnTo>
                    <a:pt x="258470" y="514502"/>
                  </a:lnTo>
                  <a:lnTo>
                    <a:pt x="258470" y="521817"/>
                  </a:lnTo>
                  <a:lnTo>
                    <a:pt x="258470" y="772972"/>
                  </a:lnTo>
                  <a:lnTo>
                    <a:pt x="7315" y="772972"/>
                  </a:lnTo>
                  <a:lnTo>
                    <a:pt x="7315" y="521817"/>
                  </a:lnTo>
                  <a:lnTo>
                    <a:pt x="258470" y="521817"/>
                  </a:lnTo>
                  <a:lnTo>
                    <a:pt x="258470" y="514502"/>
                  </a:lnTo>
                  <a:lnTo>
                    <a:pt x="7315" y="514502"/>
                  </a:lnTo>
                  <a:lnTo>
                    <a:pt x="7315" y="263347"/>
                  </a:lnTo>
                  <a:lnTo>
                    <a:pt x="258470" y="263347"/>
                  </a:lnTo>
                  <a:lnTo>
                    <a:pt x="258470" y="256032"/>
                  </a:lnTo>
                  <a:lnTo>
                    <a:pt x="7315" y="256032"/>
                  </a:lnTo>
                  <a:lnTo>
                    <a:pt x="0" y="256032"/>
                  </a:lnTo>
                  <a:lnTo>
                    <a:pt x="0" y="258470"/>
                  </a:lnTo>
                  <a:lnTo>
                    <a:pt x="0" y="780288"/>
                  </a:lnTo>
                  <a:lnTo>
                    <a:pt x="2438" y="780288"/>
                  </a:lnTo>
                  <a:lnTo>
                    <a:pt x="7315" y="780288"/>
                  </a:lnTo>
                  <a:lnTo>
                    <a:pt x="258470" y="780288"/>
                  </a:lnTo>
                  <a:lnTo>
                    <a:pt x="260908" y="780288"/>
                  </a:lnTo>
                  <a:lnTo>
                    <a:pt x="265785" y="780288"/>
                  </a:lnTo>
                  <a:lnTo>
                    <a:pt x="265785" y="775411"/>
                  </a:lnTo>
                  <a:lnTo>
                    <a:pt x="265785" y="258470"/>
                  </a:lnTo>
                  <a:lnTo>
                    <a:pt x="265785" y="256032"/>
                  </a:lnTo>
                  <a:close/>
                </a:path>
                <a:path w="2333625" h="1297305">
                  <a:moveTo>
                    <a:pt x="2333548" y="772972"/>
                  </a:moveTo>
                  <a:lnTo>
                    <a:pt x="2328672" y="772972"/>
                  </a:lnTo>
                  <a:lnTo>
                    <a:pt x="2326233" y="772972"/>
                  </a:lnTo>
                  <a:lnTo>
                    <a:pt x="2326233" y="780288"/>
                  </a:lnTo>
                  <a:lnTo>
                    <a:pt x="2326233" y="1031443"/>
                  </a:lnTo>
                  <a:lnTo>
                    <a:pt x="2075078" y="1031443"/>
                  </a:lnTo>
                  <a:lnTo>
                    <a:pt x="2075078" y="780288"/>
                  </a:lnTo>
                  <a:lnTo>
                    <a:pt x="2326233" y="780288"/>
                  </a:lnTo>
                  <a:lnTo>
                    <a:pt x="2326233" y="772972"/>
                  </a:lnTo>
                  <a:lnTo>
                    <a:pt x="2075078" y="772972"/>
                  </a:lnTo>
                  <a:lnTo>
                    <a:pt x="2070201" y="772972"/>
                  </a:lnTo>
                  <a:lnTo>
                    <a:pt x="2067763" y="772972"/>
                  </a:lnTo>
                  <a:lnTo>
                    <a:pt x="2067763" y="780288"/>
                  </a:lnTo>
                  <a:lnTo>
                    <a:pt x="2067763" y="1031443"/>
                  </a:lnTo>
                  <a:lnTo>
                    <a:pt x="1816608" y="1031443"/>
                  </a:lnTo>
                  <a:lnTo>
                    <a:pt x="1816608" y="780288"/>
                  </a:lnTo>
                  <a:lnTo>
                    <a:pt x="2067763" y="780288"/>
                  </a:lnTo>
                  <a:lnTo>
                    <a:pt x="2067763" y="772972"/>
                  </a:lnTo>
                  <a:lnTo>
                    <a:pt x="1816608" y="772972"/>
                  </a:lnTo>
                  <a:lnTo>
                    <a:pt x="1811731" y="772972"/>
                  </a:lnTo>
                  <a:lnTo>
                    <a:pt x="1809292" y="772972"/>
                  </a:lnTo>
                  <a:lnTo>
                    <a:pt x="1809292" y="780288"/>
                  </a:lnTo>
                  <a:lnTo>
                    <a:pt x="1809292" y="1031443"/>
                  </a:lnTo>
                  <a:lnTo>
                    <a:pt x="1558137" y="1031443"/>
                  </a:lnTo>
                  <a:lnTo>
                    <a:pt x="1558137" y="780288"/>
                  </a:lnTo>
                  <a:lnTo>
                    <a:pt x="1809292" y="780288"/>
                  </a:lnTo>
                  <a:lnTo>
                    <a:pt x="1809292" y="772972"/>
                  </a:lnTo>
                  <a:lnTo>
                    <a:pt x="1558137" y="772972"/>
                  </a:lnTo>
                  <a:lnTo>
                    <a:pt x="1553260" y="772972"/>
                  </a:lnTo>
                  <a:lnTo>
                    <a:pt x="1550822" y="772972"/>
                  </a:lnTo>
                  <a:lnTo>
                    <a:pt x="1550822" y="780288"/>
                  </a:lnTo>
                  <a:lnTo>
                    <a:pt x="1550822" y="1031443"/>
                  </a:lnTo>
                  <a:lnTo>
                    <a:pt x="1299667" y="1031443"/>
                  </a:lnTo>
                  <a:lnTo>
                    <a:pt x="1299667" y="780288"/>
                  </a:lnTo>
                  <a:lnTo>
                    <a:pt x="1550822" y="780288"/>
                  </a:lnTo>
                  <a:lnTo>
                    <a:pt x="1550822" y="772972"/>
                  </a:lnTo>
                  <a:lnTo>
                    <a:pt x="1299667" y="772972"/>
                  </a:lnTo>
                  <a:lnTo>
                    <a:pt x="1294790" y="772972"/>
                  </a:lnTo>
                  <a:lnTo>
                    <a:pt x="1292352" y="772972"/>
                  </a:lnTo>
                  <a:lnTo>
                    <a:pt x="1292352" y="780288"/>
                  </a:lnTo>
                  <a:lnTo>
                    <a:pt x="1292352" y="1031443"/>
                  </a:lnTo>
                  <a:lnTo>
                    <a:pt x="1041196" y="1031443"/>
                  </a:lnTo>
                  <a:lnTo>
                    <a:pt x="1041196" y="780288"/>
                  </a:lnTo>
                  <a:lnTo>
                    <a:pt x="1292352" y="780288"/>
                  </a:lnTo>
                  <a:lnTo>
                    <a:pt x="1292352" y="772972"/>
                  </a:lnTo>
                  <a:lnTo>
                    <a:pt x="1041196" y="772972"/>
                  </a:lnTo>
                  <a:lnTo>
                    <a:pt x="1041196" y="521817"/>
                  </a:lnTo>
                  <a:lnTo>
                    <a:pt x="1292352" y="521817"/>
                  </a:lnTo>
                  <a:lnTo>
                    <a:pt x="1294790" y="521817"/>
                  </a:lnTo>
                  <a:lnTo>
                    <a:pt x="1816608" y="521817"/>
                  </a:lnTo>
                  <a:lnTo>
                    <a:pt x="1816608" y="516940"/>
                  </a:lnTo>
                  <a:lnTo>
                    <a:pt x="1816608" y="514502"/>
                  </a:lnTo>
                  <a:lnTo>
                    <a:pt x="1816608" y="263347"/>
                  </a:lnTo>
                  <a:lnTo>
                    <a:pt x="1816608" y="258470"/>
                  </a:lnTo>
                  <a:lnTo>
                    <a:pt x="1816608" y="256032"/>
                  </a:lnTo>
                  <a:lnTo>
                    <a:pt x="1809292" y="256032"/>
                  </a:lnTo>
                  <a:lnTo>
                    <a:pt x="1809292" y="263347"/>
                  </a:lnTo>
                  <a:lnTo>
                    <a:pt x="1809292" y="514502"/>
                  </a:lnTo>
                  <a:lnTo>
                    <a:pt x="1558137" y="514502"/>
                  </a:lnTo>
                  <a:lnTo>
                    <a:pt x="1558137" y="263347"/>
                  </a:lnTo>
                  <a:lnTo>
                    <a:pt x="1809292" y="263347"/>
                  </a:lnTo>
                  <a:lnTo>
                    <a:pt x="1809292" y="256032"/>
                  </a:lnTo>
                  <a:lnTo>
                    <a:pt x="1558137" y="256032"/>
                  </a:lnTo>
                  <a:lnTo>
                    <a:pt x="1558137" y="0"/>
                  </a:lnTo>
                  <a:lnTo>
                    <a:pt x="1550822" y="0"/>
                  </a:lnTo>
                  <a:lnTo>
                    <a:pt x="1550822" y="256032"/>
                  </a:lnTo>
                  <a:lnTo>
                    <a:pt x="1550822" y="263347"/>
                  </a:lnTo>
                  <a:lnTo>
                    <a:pt x="1550822" y="514502"/>
                  </a:lnTo>
                  <a:lnTo>
                    <a:pt x="1299667" y="514502"/>
                  </a:lnTo>
                  <a:lnTo>
                    <a:pt x="1299667" y="263347"/>
                  </a:lnTo>
                  <a:lnTo>
                    <a:pt x="1550822" y="263347"/>
                  </a:lnTo>
                  <a:lnTo>
                    <a:pt x="1550822" y="256032"/>
                  </a:lnTo>
                  <a:lnTo>
                    <a:pt x="1299667" y="256032"/>
                  </a:lnTo>
                  <a:lnTo>
                    <a:pt x="1292352" y="256032"/>
                  </a:lnTo>
                  <a:lnTo>
                    <a:pt x="1292352" y="263347"/>
                  </a:lnTo>
                  <a:lnTo>
                    <a:pt x="1292352" y="514502"/>
                  </a:lnTo>
                  <a:lnTo>
                    <a:pt x="1041196" y="514502"/>
                  </a:lnTo>
                  <a:lnTo>
                    <a:pt x="1041196" y="263347"/>
                  </a:lnTo>
                  <a:lnTo>
                    <a:pt x="1292352" y="263347"/>
                  </a:lnTo>
                  <a:lnTo>
                    <a:pt x="1292352" y="256032"/>
                  </a:lnTo>
                  <a:lnTo>
                    <a:pt x="1041196" y="256032"/>
                  </a:lnTo>
                  <a:lnTo>
                    <a:pt x="1033881" y="256032"/>
                  </a:lnTo>
                  <a:lnTo>
                    <a:pt x="1033881" y="263347"/>
                  </a:lnTo>
                  <a:lnTo>
                    <a:pt x="1033881" y="514502"/>
                  </a:lnTo>
                  <a:lnTo>
                    <a:pt x="782726" y="514502"/>
                  </a:lnTo>
                  <a:lnTo>
                    <a:pt x="782726" y="263347"/>
                  </a:lnTo>
                  <a:lnTo>
                    <a:pt x="1033881" y="263347"/>
                  </a:lnTo>
                  <a:lnTo>
                    <a:pt x="1033881" y="256032"/>
                  </a:lnTo>
                  <a:lnTo>
                    <a:pt x="782726" y="256032"/>
                  </a:lnTo>
                  <a:lnTo>
                    <a:pt x="775411" y="256032"/>
                  </a:lnTo>
                  <a:lnTo>
                    <a:pt x="775411" y="263347"/>
                  </a:lnTo>
                  <a:lnTo>
                    <a:pt x="775411" y="514502"/>
                  </a:lnTo>
                  <a:lnTo>
                    <a:pt x="775411" y="521817"/>
                  </a:lnTo>
                  <a:lnTo>
                    <a:pt x="775411" y="775411"/>
                  </a:lnTo>
                  <a:lnTo>
                    <a:pt x="775411" y="780288"/>
                  </a:lnTo>
                  <a:lnTo>
                    <a:pt x="782726" y="780288"/>
                  </a:lnTo>
                  <a:lnTo>
                    <a:pt x="782726" y="775411"/>
                  </a:lnTo>
                  <a:lnTo>
                    <a:pt x="782726" y="521817"/>
                  </a:lnTo>
                  <a:lnTo>
                    <a:pt x="1033881" y="521817"/>
                  </a:lnTo>
                  <a:lnTo>
                    <a:pt x="1033881" y="772972"/>
                  </a:lnTo>
                  <a:lnTo>
                    <a:pt x="1033881" y="780288"/>
                  </a:lnTo>
                  <a:lnTo>
                    <a:pt x="1033881" y="1031443"/>
                  </a:lnTo>
                  <a:lnTo>
                    <a:pt x="775411" y="1031443"/>
                  </a:lnTo>
                  <a:lnTo>
                    <a:pt x="775411" y="1297228"/>
                  </a:lnTo>
                  <a:lnTo>
                    <a:pt x="1041196" y="1297228"/>
                  </a:lnTo>
                  <a:lnTo>
                    <a:pt x="1041196" y="1289913"/>
                  </a:lnTo>
                  <a:lnTo>
                    <a:pt x="782726" y="1289913"/>
                  </a:lnTo>
                  <a:lnTo>
                    <a:pt x="782726" y="1038758"/>
                  </a:lnTo>
                  <a:lnTo>
                    <a:pt x="2333548" y="1038758"/>
                  </a:lnTo>
                  <a:lnTo>
                    <a:pt x="2333548" y="1033881"/>
                  </a:lnTo>
                  <a:lnTo>
                    <a:pt x="2333548" y="1031443"/>
                  </a:lnTo>
                  <a:lnTo>
                    <a:pt x="2333548" y="780288"/>
                  </a:lnTo>
                  <a:lnTo>
                    <a:pt x="2333548" y="775411"/>
                  </a:lnTo>
                  <a:lnTo>
                    <a:pt x="2333548" y="772972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7" name="object 147"/>
            <p:cNvSpPr/>
            <p:nvPr/>
          </p:nvSpPr>
          <p:spPr>
            <a:xfrm>
              <a:off x="3625278" y="2852318"/>
              <a:ext cx="2075180" cy="1558290"/>
            </a:xfrm>
            <a:custGeom>
              <a:avLst/>
              <a:gdLst/>
              <a:ahLst/>
              <a:cxnLst/>
              <a:rect l="l" t="t" r="r" b="b"/>
              <a:pathLst>
                <a:path w="2075179" h="1558289">
                  <a:moveTo>
                    <a:pt x="2075078" y="775411"/>
                  </a:moveTo>
                  <a:lnTo>
                    <a:pt x="2067763" y="775411"/>
                  </a:lnTo>
                  <a:lnTo>
                    <a:pt x="2067763" y="782726"/>
                  </a:lnTo>
                  <a:lnTo>
                    <a:pt x="2067763" y="1033881"/>
                  </a:lnTo>
                  <a:lnTo>
                    <a:pt x="2067763" y="1041196"/>
                  </a:lnTo>
                  <a:lnTo>
                    <a:pt x="2067763" y="1292352"/>
                  </a:lnTo>
                  <a:lnTo>
                    <a:pt x="1816608" y="1292352"/>
                  </a:lnTo>
                  <a:lnTo>
                    <a:pt x="1816608" y="1041196"/>
                  </a:lnTo>
                  <a:lnTo>
                    <a:pt x="2067763" y="1041196"/>
                  </a:lnTo>
                  <a:lnTo>
                    <a:pt x="2067763" y="1033881"/>
                  </a:lnTo>
                  <a:lnTo>
                    <a:pt x="1816608" y="1033881"/>
                  </a:lnTo>
                  <a:lnTo>
                    <a:pt x="1816608" y="782726"/>
                  </a:lnTo>
                  <a:lnTo>
                    <a:pt x="2067763" y="782726"/>
                  </a:lnTo>
                  <a:lnTo>
                    <a:pt x="2067763" y="775411"/>
                  </a:lnTo>
                  <a:lnTo>
                    <a:pt x="1816608" y="775411"/>
                  </a:lnTo>
                  <a:lnTo>
                    <a:pt x="1809292" y="775411"/>
                  </a:lnTo>
                  <a:lnTo>
                    <a:pt x="1809292" y="777849"/>
                  </a:lnTo>
                  <a:lnTo>
                    <a:pt x="1809292" y="1292352"/>
                  </a:lnTo>
                  <a:lnTo>
                    <a:pt x="1558137" y="1292352"/>
                  </a:lnTo>
                  <a:lnTo>
                    <a:pt x="782726" y="1292352"/>
                  </a:lnTo>
                  <a:lnTo>
                    <a:pt x="782726" y="1041196"/>
                  </a:lnTo>
                  <a:lnTo>
                    <a:pt x="782726" y="775411"/>
                  </a:lnTo>
                  <a:lnTo>
                    <a:pt x="775411" y="775411"/>
                  </a:lnTo>
                  <a:lnTo>
                    <a:pt x="775411" y="1550822"/>
                  </a:lnTo>
                  <a:lnTo>
                    <a:pt x="524256" y="1550822"/>
                  </a:lnTo>
                  <a:lnTo>
                    <a:pt x="524256" y="1299667"/>
                  </a:lnTo>
                  <a:lnTo>
                    <a:pt x="775411" y="1299667"/>
                  </a:lnTo>
                  <a:lnTo>
                    <a:pt x="775411" y="1292352"/>
                  </a:lnTo>
                  <a:lnTo>
                    <a:pt x="524256" y="1292352"/>
                  </a:lnTo>
                  <a:lnTo>
                    <a:pt x="524256" y="1041196"/>
                  </a:lnTo>
                  <a:lnTo>
                    <a:pt x="775411" y="1041196"/>
                  </a:lnTo>
                  <a:lnTo>
                    <a:pt x="775411" y="1033881"/>
                  </a:lnTo>
                  <a:lnTo>
                    <a:pt x="524256" y="1033881"/>
                  </a:lnTo>
                  <a:lnTo>
                    <a:pt x="524256" y="782726"/>
                  </a:lnTo>
                  <a:lnTo>
                    <a:pt x="775411" y="782726"/>
                  </a:lnTo>
                  <a:lnTo>
                    <a:pt x="775411" y="775411"/>
                  </a:lnTo>
                  <a:lnTo>
                    <a:pt x="524256" y="775411"/>
                  </a:lnTo>
                  <a:lnTo>
                    <a:pt x="516940" y="775411"/>
                  </a:lnTo>
                  <a:lnTo>
                    <a:pt x="516940" y="777849"/>
                  </a:lnTo>
                  <a:lnTo>
                    <a:pt x="516940" y="1550822"/>
                  </a:lnTo>
                  <a:lnTo>
                    <a:pt x="265785" y="1550822"/>
                  </a:lnTo>
                  <a:lnTo>
                    <a:pt x="265785" y="1299667"/>
                  </a:lnTo>
                  <a:lnTo>
                    <a:pt x="516940" y="1299667"/>
                  </a:lnTo>
                  <a:lnTo>
                    <a:pt x="516940" y="1292352"/>
                  </a:lnTo>
                  <a:lnTo>
                    <a:pt x="265785" y="1292352"/>
                  </a:lnTo>
                  <a:lnTo>
                    <a:pt x="265785" y="1041196"/>
                  </a:lnTo>
                  <a:lnTo>
                    <a:pt x="265785" y="1036320"/>
                  </a:lnTo>
                  <a:lnTo>
                    <a:pt x="265785" y="7315"/>
                  </a:lnTo>
                  <a:lnTo>
                    <a:pt x="519379" y="7315"/>
                  </a:lnTo>
                  <a:lnTo>
                    <a:pt x="777849" y="7315"/>
                  </a:lnTo>
                  <a:lnTo>
                    <a:pt x="1036320" y="7315"/>
                  </a:lnTo>
                  <a:lnTo>
                    <a:pt x="1294790" y="7315"/>
                  </a:lnTo>
                  <a:lnTo>
                    <a:pt x="1553260" y="7315"/>
                  </a:lnTo>
                  <a:lnTo>
                    <a:pt x="1553260" y="0"/>
                  </a:lnTo>
                  <a:lnTo>
                    <a:pt x="258470" y="0"/>
                  </a:lnTo>
                  <a:lnTo>
                    <a:pt x="258470" y="7315"/>
                  </a:lnTo>
                  <a:lnTo>
                    <a:pt x="258470" y="1033881"/>
                  </a:lnTo>
                  <a:lnTo>
                    <a:pt x="7315" y="1033881"/>
                  </a:lnTo>
                  <a:lnTo>
                    <a:pt x="7315" y="782726"/>
                  </a:lnTo>
                  <a:lnTo>
                    <a:pt x="258470" y="782726"/>
                  </a:lnTo>
                  <a:lnTo>
                    <a:pt x="258470" y="775411"/>
                  </a:lnTo>
                  <a:lnTo>
                    <a:pt x="7315" y="775411"/>
                  </a:lnTo>
                  <a:lnTo>
                    <a:pt x="7315" y="524256"/>
                  </a:lnTo>
                  <a:lnTo>
                    <a:pt x="258470" y="524256"/>
                  </a:lnTo>
                  <a:lnTo>
                    <a:pt x="258470" y="516940"/>
                  </a:lnTo>
                  <a:lnTo>
                    <a:pt x="7315" y="516940"/>
                  </a:lnTo>
                  <a:lnTo>
                    <a:pt x="7315" y="265785"/>
                  </a:lnTo>
                  <a:lnTo>
                    <a:pt x="258470" y="265785"/>
                  </a:lnTo>
                  <a:lnTo>
                    <a:pt x="258470" y="258470"/>
                  </a:lnTo>
                  <a:lnTo>
                    <a:pt x="7315" y="258470"/>
                  </a:lnTo>
                  <a:lnTo>
                    <a:pt x="7315" y="0"/>
                  </a:lnTo>
                  <a:lnTo>
                    <a:pt x="0" y="0"/>
                  </a:lnTo>
                  <a:lnTo>
                    <a:pt x="0" y="1299667"/>
                  </a:lnTo>
                  <a:lnTo>
                    <a:pt x="7315" y="1299667"/>
                  </a:lnTo>
                  <a:lnTo>
                    <a:pt x="7315" y="1294790"/>
                  </a:lnTo>
                  <a:lnTo>
                    <a:pt x="7315" y="1041196"/>
                  </a:lnTo>
                  <a:lnTo>
                    <a:pt x="258470" y="1041196"/>
                  </a:lnTo>
                  <a:lnTo>
                    <a:pt x="258470" y="1292352"/>
                  </a:lnTo>
                  <a:lnTo>
                    <a:pt x="258470" y="1299667"/>
                  </a:lnTo>
                  <a:lnTo>
                    <a:pt x="258470" y="1550822"/>
                  </a:lnTo>
                  <a:lnTo>
                    <a:pt x="0" y="1550822"/>
                  </a:lnTo>
                  <a:lnTo>
                    <a:pt x="0" y="1558137"/>
                  </a:lnTo>
                  <a:lnTo>
                    <a:pt x="258470" y="1558137"/>
                  </a:lnTo>
                  <a:lnTo>
                    <a:pt x="265785" y="1558137"/>
                  </a:lnTo>
                  <a:lnTo>
                    <a:pt x="516940" y="1558137"/>
                  </a:lnTo>
                  <a:lnTo>
                    <a:pt x="524256" y="1558137"/>
                  </a:lnTo>
                  <a:lnTo>
                    <a:pt x="775411" y="1558137"/>
                  </a:lnTo>
                  <a:lnTo>
                    <a:pt x="782726" y="1558137"/>
                  </a:lnTo>
                  <a:lnTo>
                    <a:pt x="782726" y="1550822"/>
                  </a:lnTo>
                  <a:lnTo>
                    <a:pt x="782726" y="1299667"/>
                  </a:lnTo>
                  <a:lnTo>
                    <a:pt x="1036320" y="1299667"/>
                  </a:lnTo>
                  <a:lnTo>
                    <a:pt x="1292352" y="1299667"/>
                  </a:lnTo>
                  <a:lnTo>
                    <a:pt x="2075078" y="1299667"/>
                  </a:lnTo>
                  <a:lnTo>
                    <a:pt x="2075078" y="1292352"/>
                  </a:lnTo>
                  <a:lnTo>
                    <a:pt x="2075078" y="1041196"/>
                  </a:lnTo>
                  <a:lnTo>
                    <a:pt x="2075078" y="1033881"/>
                  </a:lnTo>
                  <a:lnTo>
                    <a:pt x="2075078" y="782726"/>
                  </a:lnTo>
                  <a:lnTo>
                    <a:pt x="2075078" y="775411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8" name="object 148"/>
            <p:cNvSpPr/>
            <p:nvPr/>
          </p:nvSpPr>
          <p:spPr>
            <a:xfrm>
              <a:off x="3625278" y="4144670"/>
              <a:ext cx="2075180" cy="1041400"/>
            </a:xfrm>
            <a:custGeom>
              <a:avLst/>
              <a:gdLst/>
              <a:ahLst/>
              <a:cxnLst/>
              <a:rect l="l" t="t" r="r" b="b"/>
              <a:pathLst>
                <a:path w="2075179" h="1041400">
                  <a:moveTo>
                    <a:pt x="2075078" y="0"/>
                  </a:moveTo>
                  <a:lnTo>
                    <a:pt x="2067763" y="0"/>
                  </a:lnTo>
                  <a:lnTo>
                    <a:pt x="2067763" y="7315"/>
                  </a:lnTo>
                  <a:lnTo>
                    <a:pt x="2067763" y="258470"/>
                  </a:lnTo>
                  <a:lnTo>
                    <a:pt x="1816608" y="258470"/>
                  </a:lnTo>
                  <a:lnTo>
                    <a:pt x="1816608" y="7315"/>
                  </a:lnTo>
                  <a:lnTo>
                    <a:pt x="2067763" y="7315"/>
                  </a:lnTo>
                  <a:lnTo>
                    <a:pt x="2067763" y="0"/>
                  </a:lnTo>
                  <a:lnTo>
                    <a:pt x="1816608" y="0"/>
                  </a:lnTo>
                  <a:lnTo>
                    <a:pt x="1809292" y="0"/>
                  </a:lnTo>
                  <a:lnTo>
                    <a:pt x="1809292" y="7315"/>
                  </a:lnTo>
                  <a:lnTo>
                    <a:pt x="1809292" y="258470"/>
                  </a:lnTo>
                  <a:lnTo>
                    <a:pt x="1558137" y="258470"/>
                  </a:lnTo>
                  <a:lnTo>
                    <a:pt x="1558137" y="7315"/>
                  </a:lnTo>
                  <a:lnTo>
                    <a:pt x="1809292" y="7315"/>
                  </a:lnTo>
                  <a:lnTo>
                    <a:pt x="1809292" y="0"/>
                  </a:lnTo>
                  <a:lnTo>
                    <a:pt x="1558137" y="0"/>
                  </a:lnTo>
                  <a:lnTo>
                    <a:pt x="1550822" y="0"/>
                  </a:lnTo>
                  <a:lnTo>
                    <a:pt x="1550822" y="7315"/>
                  </a:lnTo>
                  <a:lnTo>
                    <a:pt x="1550822" y="258470"/>
                  </a:lnTo>
                  <a:lnTo>
                    <a:pt x="1299667" y="258470"/>
                  </a:lnTo>
                  <a:lnTo>
                    <a:pt x="1299667" y="7315"/>
                  </a:lnTo>
                  <a:lnTo>
                    <a:pt x="1550822" y="7315"/>
                  </a:lnTo>
                  <a:lnTo>
                    <a:pt x="1550822" y="0"/>
                  </a:lnTo>
                  <a:lnTo>
                    <a:pt x="1299667" y="0"/>
                  </a:lnTo>
                  <a:lnTo>
                    <a:pt x="1292352" y="0"/>
                  </a:lnTo>
                  <a:lnTo>
                    <a:pt x="1292352" y="7315"/>
                  </a:lnTo>
                  <a:lnTo>
                    <a:pt x="1292352" y="258470"/>
                  </a:lnTo>
                  <a:lnTo>
                    <a:pt x="1041196" y="258470"/>
                  </a:lnTo>
                  <a:lnTo>
                    <a:pt x="1041196" y="7315"/>
                  </a:lnTo>
                  <a:lnTo>
                    <a:pt x="1292352" y="7315"/>
                  </a:lnTo>
                  <a:lnTo>
                    <a:pt x="1292352" y="0"/>
                  </a:lnTo>
                  <a:lnTo>
                    <a:pt x="1041196" y="0"/>
                  </a:lnTo>
                  <a:lnTo>
                    <a:pt x="1033881" y="0"/>
                  </a:lnTo>
                  <a:lnTo>
                    <a:pt x="1033881" y="7315"/>
                  </a:lnTo>
                  <a:lnTo>
                    <a:pt x="1033881" y="258470"/>
                  </a:lnTo>
                  <a:lnTo>
                    <a:pt x="782726" y="258470"/>
                  </a:lnTo>
                  <a:lnTo>
                    <a:pt x="782726" y="7315"/>
                  </a:lnTo>
                  <a:lnTo>
                    <a:pt x="1033881" y="7315"/>
                  </a:lnTo>
                  <a:lnTo>
                    <a:pt x="1033881" y="0"/>
                  </a:lnTo>
                  <a:lnTo>
                    <a:pt x="782726" y="0"/>
                  </a:lnTo>
                  <a:lnTo>
                    <a:pt x="775411" y="0"/>
                  </a:lnTo>
                  <a:lnTo>
                    <a:pt x="775411" y="7315"/>
                  </a:lnTo>
                  <a:lnTo>
                    <a:pt x="775411" y="258470"/>
                  </a:lnTo>
                  <a:lnTo>
                    <a:pt x="775411" y="265785"/>
                  </a:lnTo>
                  <a:lnTo>
                    <a:pt x="775411" y="516940"/>
                  </a:lnTo>
                  <a:lnTo>
                    <a:pt x="524256" y="516940"/>
                  </a:lnTo>
                  <a:lnTo>
                    <a:pt x="524256" y="265785"/>
                  </a:lnTo>
                  <a:lnTo>
                    <a:pt x="775411" y="265785"/>
                  </a:lnTo>
                  <a:lnTo>
                    <a:pt x="775411" y="258470"/>
                  </a:lnTo>
                  <a:lnTo>
                    <a:pt x="524256" y="258470"/>
                  </a:lnTo>
                  <a:lnTo>
                    <a:pt x="516940" y="258470"/>
                  </a:lnTo>
                  <a:lnTo>
                    <a:pt x="265785" y="258470"/>
                  </a:lnTo>
                  <a:lnTo>
                    <a:pt x="258470" y="258470"/>
                  </a:lnTo>
                  <a:lnTo>
                    <a:pt x="258470" y="265785"/>
                  </a:lnTo>
                  <a:lnTo>
                    <a:pt x="258470" y="1033881"/>
                  </a:lnTo>
                  <a:lnTo>
                    <a:pt x="7315" y="1033881"/>
                  </a:lnTo>
                  <a:lnTo>
                    <a:pt x="7315" y="782726"/>
                  </a:lnTo>
                  <a:lnTo>
                    <a:pt x="258470" y="782726"/>
                  </a:lnTo>
                  <a:lnTo>
                    <a:pt x="258470" y="775411"/>
                  </a:lnTo>
                  <a:lnTo>
                    <a:pt x="7315" y="775411"/>
                  </a:lnTo>
                  <a:lnTo>
                    <a:pt x="7315" y="524256"/>
                  </a:lnTo>
                  <a:lnTo>
                    <a:pt x="258470" y="524256"/>
                  </a:lnTo>
                  <a:lnTo>
                    <a:pt x="258470" y="516940"/>
                  </a:lnTo>
                  <a:lnTo>
                    <a:pt x="7315" y="516940"/>
                  </a:lnTo>
                  <a:lnTo>
                    <a:pt x="7315" y="265785"/>
                  </a:lnTo>
                  <a:lnTo>
                    <a:pt x="258470" y="265785"/>
                  </a:lnTo>
                  <a:lnTo>
                    <a:pt x="258470" y="258470"/>
                  </a:lnTo>
                  <a:lnTo>
                    <a:pt x="7315" y="258470"/>
                  </a:lnTo>
                  <a:lnTo>
                    <a:pt x="0" y="258470"/>
                  </a:lnTo>
                  <a:lnTo>
                    <a:pt x="0" y="260908"/>
                  </a:lnTo>
                  <a:lnTo>
                    <a:pt x="0" y="1041196"/>
                  </a:lnTo>
                  <a:lnTo>
                    <a:pt x="7315" y="1041196"/>
                  </a:lnTo>
                  <a:lnTo>
                    <a:pt x="258470" y="1041196"/>
                  </a:lnTo>
                  <a:lnTo>
                    <a:pt x="265785" y="1041196"/>
                  </a:lnTo>
                  <a:lnTo>
                    <a:pt x="265785" y="1036320"/>
                  </a:lnTo>
                  <a:lnTo>
                    <a:pt x="265785" y="265785"/>
                  </a:lnTo>
                  <a:lnTo>
                    <a:pt x="516940" y="265785"/>
                  </a:lnTo>
                  <a:lnTo>
                    <a:pt x="516940" y="516940"/>
                  </a:lnTo>
                  <a:lnTo>
                    <a:pt x="516940" y="519379"/>
                  </a:lnTo>
                  <a:lnTo>
                    <a:pt x="516940" y="524256"/>
                  </a:lnTo>
                  <a:lnTo>
                    <a:pt x="519379" y="524256"/>
                  </a:lnTo>
                  <a:lnTo>
                    <a:pt x="524256" y="524256"/>
                  </a:lnTo>
                  <a:lnTo>
                    <a:pt x="775411" y="524256"/>
                  </a:lnTo>
                  <a:lnTo>
                    <a:pt x="777849" y="524256"/>
                  </a:lnTo>
                  <a:lnTo>
                    <a:pt x="782726" y="524256"/>
                  </a:lnTo>
                  <a:lnTo>
                    <a:pt x="782726" y="519379"/>
                  </a:lnTo>
                  <a:lnTo>
                    <a:pt x="782726" y="516940"/>
                  </a:lnTo>
                  <a:lnTo>
                    <a:pt x="782726" y="265785"/>
                  </a:lnTo>
                  <a:lnTo>
                    <a:pt x="1033881" y="265785"/>
                  </a:lnTo>
                  <a:lnTo>
                    <a:pt x="1036320" y="265785"/>
                  </a:lnTo>
                  <a:lnTo>
                    <a:pt x="1041196" y="265785"/>
                  </a:lnTo>
                  <a:lnTo>
                    <a:pt x="1292352" y="265785"/>
                  </a:lnTo>
                  <a:lnTo>
                    <a:pt x="1292352" y="519379"/>
                  </a:lnTo>
                  <a:lnTo>
                    <a:pt x="1292352" y="524256"/>
                  </a:lnTo>
                  <a:lnTo>
                    <a:pt x="1299667" y="524256"/>
                  </a:lnTo>
                  <a:lnTo>
                    <a:pt x="1299667" y="519379"/>
                  </a:lnTo>
                  <a:lnTo>
                    <a:pt x="1299667" y="265785"/>
                  </a:lnTo>
                  <a:lnTo>
                    <a:pt x="1550822" y="265785"/>
                  </a:lnTo>
                  <a:lnTo>
                    <a:pt x="1550822" y="516940"/>
                  </a:lnTo>
                  <a:lnTo>
                    <a:pt x="1550822" y="524256"/>
                  </a:lnTo>
                  <a:lnTo>
                    <a:pt x="1550822" y="775411"/>
                  </a:lnTo>
                  <a:lnTo>
                    <a:pt x="1292352" y="775411"/>
                  </a:lnTo>
                  <a:lnTo>
                    <a:pt x="1292352" y="777849"/>
                  </a:lnTo>
                  <a:lnTo>
                    <a:pt x="1292352" y="782726"/>
                  </a:lnTo>
                  <a:lnTo>
                    <a:pt x="1292352" y="1033881"/>
                  </a:lnTo>
                  <a:lnTo>
                    <a:pt x="1036320" y="1033881"/>
                  </a:lnTo>
                  <a:lnTo>
                    <a:pt x="1036320" y="1041196"/>
                  </a:lnTo>
                  <a:lnTo>
                    <a:pt x="1292352" y="1041196"/>
                  </a:lnTo>
                  <a:lnTo>
                    <a:pt x="1299667" y="1041196"/>
                  </a:lnTo>
                  <a:lnTo>
                    <a:pt x="1299667" y="1033881"/>
                  </a:lnTo>
                  <a:lnTo>
                    <a:pt x="1299667" y="782726"/>
                  </a:lnTo>
                  <a:lnTo>
                    <a:pt x="1550822" y="782726"/>
                  </a:lnTo>
                  <a:lnTo>
                    <a:pt x="2075078" y="782726"/>
                  </a:lnTo>
                  <a:lnTo>
                    <a:pt x="2075078" y="775411"/>
                  </a:lnTo>
                  <a:lnTo>
                    <a:pt x="2075078" y="524256"/>
                  </a:lnTo>
                  <a:lnTo>
                    <a:pt x="2075078" y="516940"/>
                  </a:lnTo>
                  <a:lnTo>
                    <a:pt x="2070201" y="516940"/>
                  </a:lnTo>
                  <a:lnTo>
                    <a:pt x="2067763" y="516940"/>
                  </a:lnTo>
                  <a:lnTo>
                    <a:pt x="2067763" y="524256"/>
                  </a:lnTo>
                  <a:lnTo>
                    <a:pt x="2067763" y="775411"/>
                  </a:lnTo>
                  <a:lnTo>
                    <a:pt x="1816608" y="775411"/>
                  </a:lnTo>
                  <a:lnTo>
                    <a:pt x="1816608" y="524256"/>
                  </a:lnTo>
                  <a:lnTo>
                    <a:pt x="2067763" y="524256"/>
                  </a:lnTo>
                  <a:lnTo>
                    <a:pt x="2067763" y="516940"/>
                  </a:lnTo>
                  <a:lnTo>
                    <a:pt x="1816608" y="516940"/>
                  </a:lnTo>
                  <a:lnTo>
                    <a:pt x="1811731" y="516940"/>
                  </a:lnTo>
                  <a:lnTo>
                    <a:pt x="1809292" y="516940"/>
                  </a:lnTo>
                  <a:lnTo>
                    <a:pt x="1809292" y="524256"/>
                  </a:lnTo>
                  <a:lnTo>
                    <a:pt x="1809292" y="775411"/>
                  </a:lnTo>
                  <a:lnTo>
                    <a:pt x="1558137" y="775411"/>
                  </a:lnTo>
                  <a:lnTo>
                    <a:pt x="1558137" y="524256"/>
                  </a:lnTo>
                  <a:lnTo>
                    <a:pt x="1809292" y="524256"/>
                  </a:lnTo>
                  <a:lnTo>
                    <a:pt x="1809292" y="516940"/>
                  </a:lnTo>
                  <a:lnTo>
                    <a:pt x="1558137" y="516940"/>
                  </a:lnTo>
                  <a:lnTo>
                    <a:pt x="1558137" y="265785"/>
                  </a:lnTo>
                  <a:lnTo>
                    <a:pt x="1809292" y="265785"/>
                  </a:lnTo>
                  <a:lnTo>
                    <a:pt x="1811731" y="265785"/>
                  </a:lnTo>
                  <a:lnTo>
                    <a:pt x="1816608" y="265785"/>
                  </a:lnTo>
                  <a:lnTo>
                    <a:pt x="2067763" y="265785"/>
                  </a:lnTo>
                  <a:lnTo>
                    <a:pt x="2070201" y="265785"/>
                  </a:lnTo>
                  <a:lnTo>
                    <a:pt x="2075078" y="265785"/>
                  </a:lnTo>
                  <a:lnTo>
                    <a:pt x="2075078" y="258470"/>
                  </a:lnTo>
                  <a:lnTo>
                    <a:pt x="2075078" y="7315"/>
                  </a:lnTo>
                  <a:lnTo>
                    <a:pt x="2075078" y="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9" name="object 149"/>
            <p:cNvSpPr/>
            <p:nvPr/>
          </p:nvSpPr>
          <p:spPr>
            <a:xfrm>
              <a:off x="3625278" y="4920081"/>
              <a:ext cx="2070735" cy="1041400"/>
            </a:xfrm>
            <a:custGeom>
              <a:avLst/>
              <a:gdLst/>
              <a:ahLst/>
              <a:cxnLst/>
              <a:rect l="l" t="t" r="r" b="b"/>
              <a:pathLst>
                <a:path w="2070735" h="1041400">
                  <a:moveTo>
                    <a:pt x="2070201" y="0"/>
                  </a:moveTo>
                  <a:lnTo>
                    <a:pt x="1811731" y="0"/>
                  </a:lnTo>
                  <a:lnTo>
                    <a:pt x="1558137" y="0"/>
                  </a:lnTo>
                  <a:lnTo>
                    <a:pt x="1550822" y="0"/>
                  </a:lnTo>
                  <a:lnTo>
                    <a:pt x="1550822" y="7315"/>
                  </a:lnTo>
                  <a:lnTo>
                    <a:pt x="1550822" y="775411"/>
                  </a:lnTo>
                  <a:lnTo>
                    <a:pt x="1299667" y="775411"/>
                  </a:lnTo>
                  <a:lnTo>
                    <a:pt x="1299667" y="524256"/>
                  </a:lnTo>
                  <a:lnTo>
                    <a:pt x="1550822" y="524256"/>
                  </a:lnTo>
                  <a:lnTo>
                    <a:pt x="1550822" y="516940"/>
                  </a:lnTo>
                  <a:lnTo>
                    <a:pt x="1299667" y="516940"/>
                  </a:lnTo>
                  <a:lnTo>
                    <a:pt x="1299667" y="265785"/>
                  </a:lnTo>
                  <a:lnTo>
                    <a:pt x="1550822" y="265785"/>
                  </a:lnTo>
                  <a:lnTo>
                    <a:pt x="1550822" y="258470"/>
                  </a:lnTo>
                  <a:lnTo>
                    <a:pt x="1299667" y="258470"/>
                  </a:lnTo>
                  <a:lnTo>
                    <a:pt x="1299667" y="7315"/>
                  </a:lnTo>
                  <a:lnTo>
                    <a:pt x="1550822" y="7315"/>
                  </a:lnTo>
                  <a:lnTo>
                    <a:pt x="1550822" y="0"/>
                  </a:lnTo>
                  <a:lnTo>
                    <a:pt x="1299667" y="0"/>
                  </a:lnTo>
                  <a:lnTo>
                    <a:pt x="1292352" y="0"/>
                  </a:lnTo>
                  <a:lnTo>
                    <a:pt x="1292352" y="7315"/>
                  </a:lnTo>
                  <a:lnTo>
                    <a:pt x="1292352" y="258470"/>
                  </a:lnTo>
                  <a:lnTo>
                    <a:pt x="1292352" y="265785"/>
                  </a:lnTo>
                  <a:lnTo>
                    <a:pt x="1292352" y="516940"/>
                  </a:lnTo>
                  <a:lnTo>
                    <a:pt x="1041196" y="516940"/>
                  </a:lnTo>
                  <a:lnTo>
                    <a:pt x="1041196" y="265785"/>
                  </a:lnTo>
                  <a:lnTo>
                    <a:pt x="1292352" y="265785"/>
                  </a:lnTo>
                  <a:lnTo>
                    <a:pt x="1292352" y="258470"/>
                  </a:lnTo>
                  <a:lnTo>
                    <a:pt x="1041196" y="258470"/>
                  </a:lnTo>
                  <a:lnTo>
                    <a:pt x="1033881" y="258470"/>
                  </a:lnTo>
                  <a:lnTo>
                    <a:pt x="1033881" y="265785"/>
                  </a:lnTo>
                  <a:lnTo>
                    <a:pt x="1033881" y="516940"/>
                  </a:lnTo>
                  <a:lnTo>
                    <a:pt x="1033881" y="524256"/>
                  </a:lnTo>
                  <a:lnTo>
                    <a:pt x="1036320" y="524256"/>
                  </a:lnTo>
                  <a:lnTo>
                    <a:pt x="1041196" y="524256"/>
                  </a:lnTo>
                  <a:lnTo>
                    <a:pt x="1292352" y="524256"/>
                  </a:lnTo>
                  <a:lnTo>
                    <a:pt x="1292352" y="775411"/>
                  </a:lnTo>
                  <a:lnTo>
                    <a:pt x="1292352" y="782726"/>
                  </a:lnTo>
                  <a:lnTo>
                    <a:pt x="1292352" y="1033881"/>
                  </a:lnTo>
                  <a:lnTo>
                    <a:pt x="1041196" y="1033881"/>
                  </a:lnTo>
                  <a:lnTo>
                    <a:pt x="1041196" y="782726"/>
                  </a:lnTo>
                  <a:lnTo>
                    <a:pt x="1292352" y="782726"/>
                  </a:lnTo>
                  <a:lnTo>
                    <a:pt x="1292352" y="775411"/>
                  </a:lnTo>
                  <a:lnTo>
                    <a:pt x="1041196" y="775411"/>
                  </a:lnTo>
                  <a:lnTo>
                    <a:pt x="1036320" y="775411"/>
                  </a:lnTo>
                  <a:lnTo>
                    <a:pt x="1033881" y="775411"/>
                  </a:lnTo>
                  <a:lnTo>
                    <a:pt x="1033881" y="782726"/>
                  </a:lnTo>
                  <a:lnTo>
                    <a:pt x="1033881" y="1033881"/>
                  </a:lnTo>
                  <a:lnTo>
                    <a:pt x="782726" y="1033881"/>
                  </a:lnTo>
                  <a:lnTo>
                    <a:pt x="782726" y="782726"/>
                  </a:lnTo>
                  <a:lnTo>
                    <a:pt x="1033881" y="782726"/>
                  </a:lnTo>
                  <a:lnTo>
                    <a:pt x="1033881" y="775411"/>
                  </a:lnTo>
                  <a:lnTo>
                    <a:pt x="782726" y="775411"/>
                  </a:lnTo>
                  <a:lnTo>
                    <a:pt x="777849" y="775411"/>
                  </a:lnTo>
                  <a:lnTo>
                    <a:pt x="775411" y="775411"/>
                  </a:lnTo>
                  <a:lnTo>
                    <a:pt x="775411" y="782726"/>
                  </a:lnTo>
                  <a:lnTo>
                    <a:pt x="775411" y="1033881"/>
                  </a:lnTo>
                  <a:lnTo>
                    <a:pt x="524256" y="1033881"/>
                  </a:lnTo>
                  <a:lnTo>
                    <a:pt x="524256" y="782726"/>
                  </a:lnTo>
                  <a:lnTo>
                    <a:pt x="775411" y="782726"/>
                  </a:lnTo>
                  <a:lnTo>
                    <a:pt x="775411" y="775411"/>
                  </a:lnTo>
                  <a:lnTo>
                    <a:pt x="524256" y="775411"/>
                  </a:lnTo>
                  <a:lnTo>
                    <a:pt x="519379" y="775411"/>
                  </a:lnTo>
                  <a:lnTo>
                    <a:pt x="516940" y="775411"/>
                  </a:lnTo>
                  <a:lnTo>
                    <a:pt x="516940" y="782726"/>
                  </a:lnTo>
                  <a:lnTo>
                    <a:pt x="516940" y="1033881"/>
                  </a:lnTo>
                  <a:lnTo>
                    <a:pt x="265785" y="1033881"/>
                  </a:lnTo>
                  <a:lnTo>
                    <a:pt x="265785" y="782726"/>
                  </a:lnTo>
                  <a:lnTo>
                    <a:pt x="516940" y="782726"/>
                  </a:lnTo>
                  <a:lnTo>
                    <a:pt x="516940" y="775411"/>
                  </a:lnTo>
                  <a:lnTo>
                    <a:pt x="265785" y="775411"/>
                  </a:lnTo>
                  <a:lnTo>
                    <a:pt x="265785" y="524256"/>
                  </a:lnTo>
                  <a:lnTo>
                    <a:pt x="265785" y="519379"/>
                  </a:lnTo>
                  <a:lnTo>
                    <a:pt x="265785" y="516940"/>
                  </a:lnTo>
                  <a:lnTo>
                    <a:pt x="265785" y="265785"/>
                  </a:lnTo>
                  <a:lnTo>
                    <a:pt x="265785" y="260908"/>
                  </a:lnTo>
                  <a:lnTo>
                    <a:pt x="265785" y="258470"/>
                  </a:lnTo>
                  <a:lnTo>
                    <a:pt x="258470" y="258470"/>
                  </a:lnTo>
                  <a:lnTo>
                    <a:pt x="258470" y="1033881"/>
                  </a:lnTo>
                  <a:lnTo>
                    <a:pt x="7315" y="1033881"/>
                  </a:lnTo>
                  <a:lnTo>
                    <a:pt x="7315" y="782726"/>
                  </a:lnTo>
                  <a:lnTo>
                    <a:pt x="258470" y="782726"/>
                  </a:lnTo>
                  <a:lnTo>
                    <a:pt x="258470" y="775411"/>
                  </a:lnTo>
                  <a:lnTo>
                    <a:pt x="7315" y="775411"/>
                  </a:lnTo>
                  <a:lnTo>
                    <a:pt x="7315" y="524256"/>
                  </a:lnTo>
                  <a:lnTo>
                    <a:pt x="258470" y="524256"/>
                  </a:lnTo>
                  <a:lnTo>
                    <a:pt x="258470" y="516940"/>
                  </a:lnTo>
                  <a:lnTo>
                    <a:pt x="7315" y="516940"/>
                  </a:lnTo>
                  <a:lnTo>
                    <a:pt x="7315" y="265785"/>
                  </a:lnTo>
                  <a:lnTo>
                    <a:pt x="258470" y="265785"/>
                  </a:lnTo>
                  <a:lnTo>
                    <a:pt x="258470" y="258470"/>
                  </a:lnTo>
                  <a:lnTo>
                    <a:pt x="7315" y="258470"/>
                  </a:lnTo>
                  <a:lnTo>
                    <a:pt x="0" y="258470"/>
                  </a:lnTo>
                  <a:lnTo>
                    <a:pt x="0" y="260908"/>
                  </a:lnTo>
                  <a:lnTo>
                    <a:pt x="0" y="1041196"/>
                  </a:lnTo>
                  <a:lnTo>
                    <a:pt x="7315" y="1041196"/>
                  </a:lnTo>
                  <a:lnTo>
                    <a:pt x="1299667" y="1041196"/>
                  </a:lnTo>
                  <a:lnTo>
                    <a:pt x="1299667" y="1036320"/>
                  </a:lnTo>
                  <a:lnTo>
                    <a:pt x="1299667" y="1033881"/>
                  </a:lnTo>
                  <a:lnTo>
                    <a:pt x="1299667" y="782726"/>
                  </a:lnTo>
                  <a:lnTo>
                    <a:pt x="1550822" y="782726"/>
                  </a:lnTo>
                  <a:lnTo>
                    <a:pt x="1553260" y="782726"/>
                  </a:lnTo>
                  <a:lnTo>
                    <a:pt x="1558137" y="782726"/>
                  </a:lnTo>
                  <a:lnTo>
                    <a:pt x="1558137" y="777849"/>
                  </a:lnTo>
                  <a:lnTo>
                    <a:pt x="1558137" y="7315"/>
                  </a:lnTo>
                  <a:lnTo>
                    <a:pt x="1811731" y="7315"/>
                  </a:lnTo>
                  <a:lnTo>
                    <a:pt x="2070201" y="7315"/>
                  </a:lnTo>
                  <a:lnTo>
                    <a:pt x="2070201" y="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0" name="object 150"/>
          <p:cNvSpPr txBox="1"/>
          <p:nvPr/>
        </p:nvSpPr>
        <p:spPr>
          <a:xfrm>
            <a:off x="4145889" y="1046683"/>
            <a:ext cx="259079" cy="259079"/>
          </a:xfrm>
          <a:prstGeom prst="rect">
            <a:avLst/>
          </a:prstGeom>
          <a:ln w="7315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3175">
              <a:lnSpc>
                <a:spcPts val="705"/>
              </a:lnSpc>
            </a:pPr>
            <a:r>
              <a:rPr sz="700" spc="5" dirty="0">
                <a:latin typeface="Courier New"/>
                <a:cs typeface="Courier New"/>
              </a:rPr>
              <a:t>1</a:t>
            </a:r>
            <a:endParaRPr sz="700">
              <a:latin typeface="Courier New"/>
              <a:cs typeface="Courier New"/>
            </a:endParaRPr>
          </a:p>
        </p:txBody>
      </p:sp>
      <p:sp>
        <p:nvSpPr>
          <p:cNvPr id="151" name="object 151"/>
          <p:cNvSpPr txBox="1"/>
          <p:nvPr/>
        </p:nvSpPr>
        <p:spPr>
          <a:xfrm>
            <a:off x="2078126" y="1305153"/>
            <a:ext cx="259079" cy="259079"/>
          </a:xfrm>
          <a:prstGeom prst="rect">
            <a:avLst/>
          </a:prstGeom>
          <a:ln w="7315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3175">
              <a:lnSpc>
                <a:spcPts val="705"/>
              </a:lnSpc>
            </a:pPr>
            <a:r>
              <a:rPr sz="700" spc="5" dirty="0">
                <a:latin typeface="Courier New"/>
                <a:cs typeface="Courier New"/>
              </a:rPr>
              <a:t>2</a:t>
            </a:r>
            <a:endParaRPr sz="700">
              <a:latin typeface="Courier New"/>
              <a:cs typeface="Courier New"/>
            </a:endParaRPr>
          </a:p>
        </p:txBody>
      </p:sp>
      <p:sp>
        <p:nvSpPr>
          <p:cNvPr id="152" name="object 152"/>
          <p:cNvSpPr txBox="1"/>
          <p:nvPr/>
        </p:nvSpPr>
        <p:spPr>
          <a:xfrm>
            <a:off x="2853537" y="1305153"/>
            <a:ext cx="259079" cy="259079"/>
          </a:xfrm>
          <a:prstGeom prst="rect">
            <a:avLst/>
          </a:prstGeom>
          <a:ln w="7315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3175">
              <a:lnSpc>
                <a:spcPts val="705"/>
              </a:lnSpc>
            </a:pPr>
            <a:r>
              <a:rPr sz="700" spc="5" dirty="0">
                <a:latin typeface="Courier New"/>
                <a:cs typeface="Courier New"/>
              </a:rPr>
              <a:t>3</a:t>
            </a:r>
            <a:endParaRPr sz="700">
              <a:latin typeface="Courier New"/>
              <a:cs typeface="Courier New"/>
            </a:endParaRPr>
          </a:p>
        </p:txBody>
      </p:sp>
      <p:sp>
        <p:nvSpPr>
          <p:cNvPr id="153" name="object 153"/>
          <p:cNvSpPr txBox="1"/>
          <p:nvPr/>
        </p:nvSpPr>
        <p:spPr>
          <a:xfrm>
            <a:off x="3628948" y="1305153"/>
            <a:ext cx="259079" cy="259079"/>
          </a:xfrm>
          <a:prstGeom prst="rect">
            <a:avLst/>
          </a:prstGeom>
          <a:ln w="7315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3175">
              <a:lnSpc>
                <a:spcPts val="705"/>
              </a:lnSpc>
            </a:pPr>
            <a:r>
              <a:rPr sz="700" spc="5" dirty="0">
                <a:latin typeface="Courier New"/>
                <a:cs typeface="Courier New"/>
              </a:rPr>
              <a:t>4</a:t>
            </a:r>
            <a:endParaRPr sz="700">
              <a:latin typeface="Courier New"/>
              <a:cs typeface="Courier New"/>
            </a:endParaRPr>
          </a:p>
        </p:txBody>
      </p:sp>
      <p:sp>
        <p:nvSpPr>
          <p:cNvPr id="154" name="object 154"/>
          <p:cNvSpPr txBox="1"/>
          <p:nvPr/>
        </p:nvSpPr>
        <p:spPr>
          <a:xfrm>
            <a:off x="3370478" y="2080564"/>
            <a:ext cx="259079" cy="259079"/>
          </a:xfrm>
          <a:prstGeom prst="rect">
            <a:avLst/>
          </a:prstGeom>
          <a:ln w="7315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3175">
              <a:lnSpc>
                <a:spcPts val="705"/>
              </a:lnSpc>
            </a:pPr>
            <a:r>
              <a:rPr sz="700" spc="5" dirty="0">
                <a:latin typeface="Courier New"/>
                <a:cs typeface="Courier New"/>
              </a:rPr>
              <a:t>5</a:t>
            </a:r>
            <a:endParaRPr sz="700">
              <a:latin typeface="Courier New"/>
              <a:cs typeface="Courier New"/>
            </a:endParaRPr>
          </a:p>
        </p:txBody>
      </p:sp>
      <p:sp>
        <p:nvSpPr>
          <p:cNvPr id="155" name="object 155"/>
          <p:cNvSpPr txBox="1"/>
          <p:nvPr/>
        </p:nvSpPr>
        <p:spPr>
          <a:xfrm>
            <a:off x="3628948" y="2597505"/>
            <a:ext cx="259079" cy="259079"/>
          </a:xfrm>
          <a:prstGeom prst="rect">
            <a:avLst/>
          </a:prstGeom>
          <a:ln w="7315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3175">
              <a:lnSpc>
                <a:spcPts val="705"/>
              </a:lnSpc>
            </a:pPr>
            <a:r>
              <a:rPr sz="700" spc="5" dirty="0">
                <a:latin typeface="Courier New"/>
                <a:cs typeface="Courier New"/>
              </a:rPr>
              <a:t>6</a:t>
            </a:r>
            <a:endParaRPr sz="700">
              <a:latin typeface="Courier New"/>
              <a:cs typeface="Courier New"/>
            </a:endParaRPr>
          </a:p>
        </p:txBody>
      </p:sp>
      <p:sp>
        <p:nvSpPr>
          <p:cNvPr id="156" name="object 156"/>
          <p:cNvSpPr txBox="1"/>
          <p:nvPr/>
        </p:nvSpPr>
        <p:spPr>
          <a:xfrm>
            <a:off x="4145889" y="3372916"/>
            <a:ext cx="259079" cy="259079"/>
          </a:xfrm>
          <a:prstGeom prst="rect">
            <a:avLst/>
          </a:prstGeom>
          <a:ln w="7315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3175">
              <a:lnSpc>
                <a:spcPts val="705"/>
              </a:lnSpc>
            </a:pPr>
            <a:r>
              <a:rPr sz="700" spc="5" dirty="0">
                <a:latin typeface="Courier New"/>
                <a:cs typeface="Courier New"/>
              </a:rPr>
              <a:t>7</a:t>
            </a:r>
            <a:endParaRPr sz="700">
              <a:latin typeface="Courier New"/>
              <a:cs typeface="Courier New"/>
            </a:endParaRPr>
          </a:p>
        </p:txBody>
      </p:sp>
      <p:sp>
        <p:nvSpPr>
          <p:cNvPr id="157" name="object 157"/>
          <p:cNvSpPr txBox="1"/>
          <p:nvPr/>
        </p:nvSpPr>
        <p:spPr>
          <a:xfrm>
            <a:off x="5438241" y="3372916"/>
            <a:ext cx="259079" cy="259079"/>
          </a:xfrm>
          <a:prstGeom prst="rect">
            <a:avLst/>
          </a:prstGeom>
          <a:ln w="7315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3175">
              <a:lnSpc>
                <a:spcPts val="705"/>
              </a:lnSpc>
            </a:pPr>
            <a:r>
              <a:rPr sz="700" spc="5" dirty="0">
                <a:latin typeface="Courier New"/>
                <a:cs typeface="Courier New"/>
              </a:rPr>
              <a:t>8</a:t>
            </a:r>
            <a:endParaRPr sz="700">
              <a:latin typeface="Courier New"/>
              <a:cs typeface="Courier New"/>
            </a:endParaRPr>
          </a:p>
        </p:txBody>
      </p:sp>
      <p:sp>
        <p:nvSpPr>
          <p:cNvPr id="158" name="object 158"/>
          <p:cNvSpPr txBox="1"/>
          <p:nvPr/>
        </p:nvSpPr>
        <p:spPr>
          <a:xfrm>
            <a:off x="4921300" y="3889857"/>
            <a:ext cx="259079" cy="259079"/>
          </a:xfrm>
          <a:prstGeom prst="rect">
            <a:avLst/>
          </a:prstGeom>
          <a:ln w="7315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3175">
              <a:lnSpc>
                <a:spcPts val="705"/>
              </a:lnSpc>
            </a:pPr>
            <a:r>
              <a:rPr sz="700" spc="5" dirty="0">
                <a:latin typeface="Courier New"/>
                <a:cs typeface="Courier New"/>
              </a:rPr>
              <a:t>9</a:t>
            </a:r>
            <a:endParaRPr sz="700">
              <a:latin typeface="Courier New"/>
              <a:cs typeface="Courier New"/>
            </a:endParaRPr>
          </a:p>
        </p:txBody>
      </p:sp>
      <p:sp>
        <p:nvSpPr>
          <p:cNvPr id="159" name="object 159"/>
          <p:cNvSpPr txBox="1"/>
          <p:nvPr/>
        </p:nvSpPr>
        <p:spPr>
          <a:xfrm>
            <a:off x="3628948" y="4148328"/>
            <a:ext cx="259079" cy="259079"/>
          </a:xfrm>
          <a:prstGeom prst="rect">
            <a:avLst/>
          </a:prstGeom>
          <a:ln w="7315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3175">
              <a:lnSpc>
                <a:spcPts val="705"/>
              </a:lnSpc>
            </a:pPr>
            <a:r>
              <a:rPr sz="700" spc="-25" dirty="0">
                <a:latin typeface="Courier New"/>
                <a:cs typeface="Courier New"/>
              </a:rPr>
              <a:t>10</a:t>
            </a:r>
            <a:endParaRPr sz="700">
              <a:latin typeface="Courier New"/>
              <a:cs typeface="Courier New"/>
            </a:endParaRPr>
          </a:p>
        </p:txBody>
      </p:sp>
      <p:sp>
        <p:nvSpPr>
          <p:cNvPr id="160" name="object 160"/>
          <p:cNvSpPr txBox="1"/>
          <p:nvPr/>
        </p:nvSpPr>
        <p:spPr>
          <a:xfrm>
            <a:off x="4921300" y="4665268"/>
            <a:ext cx="259079" cy="259079"/>
          </a:xfrm>
          <a:prstGeom prst="rect">
            <a:avLst/>
          </a:prstGeom>
          <a:ln w="7315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3175">
              <a:lnSpc>
                <a:spcPts val="705"/>
              </a:lnSpc>
            </a:pPr>
            <a:r>
              <a:rPr sz="700" spc="-25" dirty="0">
                <a:latin typeface="Courier New"/>
                <a:cs typeface="Courier New"/>
              </a:rPr>
              <a:t>11</a:t>
            </a:r>
            <a:endParaRPr sz="700">
              <a:latin typeface="Courier New"/>
              <a:cs typeface="Courier New"/>
            </a:endParaRPr>
          </a:p>
        </p:txBody>
      </p:sp>
      <p:sp>
        <p:nvSpPr>
          <p:cNvPr id="161" name="object 161"/>
          <p:cNvSpPr txBox="1"/>
          <p:nvPr/>
        </p:nvSpPr>
        <p:spPr>
          <a:xfrm>
            <a:off x="4404359" y="5182209"/>
            <a:ext cx="259079" cy="259079"/>
          </a:xfrm>
          <a:prstGeom prst="rect">
            <a:avLst/>
          </a:prstGeom>
          <a:ln w="7315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3175">
              <a:lnSpc>
                <a:spcPts val="705"/>
              </a:lnSpc>
            </a:pPr>
            <a:r>
              <a:rPr sz="700" spc="-25" dirty="0">
                <a:latin typeface="Courier New"/>
                <a:cs typeface="Courier New"/>
              </a:rPr>
              <a:t>12</a:t>
            </a:r>
            <a:endParaRPr sz="700">
              <a:latin typeface="Courier New"/>
              <a:cs typeface="Courier New"/>
            </a:endParaRPr>
          </a:p>
        </p:txBody>
      </p:sp>
      <p:sp>
        <p:nvSpPr>
          <p:cNvPr id="162" name="object 162"/>
          <p:cNvSpPr txBox="1"/>
          <p:nvPr/>
        </p:nvSpPr>
        <p:spPr>
          <a:xfrm>
            <a:off x="3370478" y="5699150"/>
            <a:ext cx="259079" cy="259079"/>
          </a:xfrm>
          <a:prstGeom prst="rect">
            <a:avLst/>
          </a:prstGeom>
          <a:ln w="7315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3175">
              <a:lnSpc>
                <a:spcPts val="705"/>
              </a:lnSpc>
            </a:pPr>
            <a:r>
              <a:rPr sz="700" spc="-25" dirty="0">
                <a:latin typeface="Courier New"/>
                <a:cs typeface="Courier New"/>
              </a:rPr>
              <a:t>13</a:t>
            </a:r>
            <a:endParaRPr sz="700">
              <a:latin typeface="Courier New"/>
              <a:cs typeface="Courier New"/>
            </a:endParaRPr>
          </a:p>
        </p:txBody>
      </p:sp>
      <p:sp>
        <p:nvSpPr>
          <p:cNvPr id="163" name="object 163"/>
          <p:cNvSpPr txBox="1"/>
          <p:nvPr/>
        </p:nvSpPr>
        <p:spPr>
          <a:xfrm>
            <a:off x="3927144" y="6092444"/>
            <a:ext cx="463550" cy="219075"/>
          </a:xfrm>
          <a:prstGeom prst="rect">
            <a:avLst/>
          </a:prstGeom>
        </p:spPr>
        <p:txBody>
          <a:bodyPr vert="horz" wrap="square" lIns="0" tIns="1460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4"/>
              </a:spcBef>
            </a:pPr>
            <a:r>
              <a:rPr sz="1250" b="1" u="sng" spc="-20" dirty="0">
                <a:uFill>
                  <a:solidFill>
                    <a:srgbClr val="000000"/>
                  </a:solidFill>
                </a:uFill>
                <a:latin typeface="Arial"/>
                <a:cs typeface="Arial"/>
              </a:rPr>
              <a:t>Down</a:t>
            </a:r>
            <a:endParaRPr sz="1250">
              <a:latin typeface="Arial"/>
              <a:cs typeface="Arial"/>
            </a:endParaRPr>
          </a:p>
        </p:txBody>
      </p:sp>
      <p:sp>
        <p:nvSpPr>
          <p:cNvPr id="164" name="object 164"/>
          <p:cNvSpPr txBox="1"/>
          <p:nvPr/>
        </p:nvSpPr>
        <p:spPr>
          <a:xfrm>
            <a:off x="4051503" y="6277762"/>
            <a:ext cx="3230880" cy="1883208"/>
          </a:xfrm>
          <a:prstGeom prst="rect">
            <a:avLst/>
          </a:prstGeom>
        </p:spPr>
        <p:txBody>
          <a:bodyPr vert="horz" wrap="square" lIns="0" tIns="23495" rIns="0" bIns="0" rtlCol="0">
            <a:spAutoFit/>
          </a:bodyPr>
          <a:lstStyle/>
          <a:p>
            <a:pPr marL="12700" marR="146685">
              <a:lnSpc>
                <a:spcPts val="1210"/>
              </a:lnSpc>
              <a:spcBef>
                <a:spcPts val="185"/>
              </a:spcBef>
            </a:pPr>
            <a:r>
              <a:rPr sz="1050" b="1" dirty="0">
                <a:latin typeface="Arial"/>
                <a:cs typeface="Arial"/>
              </a:rPr>
              <a:t>1.</a:t>
            </a:r>
            <a:r>
              <a:rPr sz="1050" b="1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pell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ize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G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ub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(in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French)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you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would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spc="-25" dirty="0">
                <a:latin typeface="Arial"/>
                <a:cs typeface="Arial"/>
              </a:rPr>
              <a:t>use </a:t>
            </a:r>
            <a:r>
              <a:rPr sz="1050" dirty="0">
                <a:latin typeface="Arial"/>
                <a:cs typeface="Arial"/>
              </a:rPr>
              <a:t>for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a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neonate</a:t>
            </a:r>
            <a:endParaRPr sz="1050" dirty="0">
              <a:latin typeface="Arial"/>
              <a:cs typeface="Arial"/>
            </a:endParaRPr>
          </a:p>
          <a:p>
            <a:pPr marL="12700" marR="5080">
              <a:lnSpc>
                <a:spcPts val="1210"/>
              </a:lnSpc>
            </a:pPr>
            <a:r>
              <a:rPr sz="1050" b="1" dirty="0">
                <a:latin typeface="Arial"/>
                <a:cs typeface="Arial"/>
              </a:rPr>
              <a:t>3.</a:t>
            </a:r>
            <a:r>
              <a:rPr sz="1050" b="1" spc="-2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pel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umber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f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econds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etween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pulse</a:t>
            </a:r>
            <a:r>
              <a:rPr sz="1050" spc="-10" dirty="0">
                <a:latin typeface="Arial"/>
                <a:cs typeface="Arial"/>
              </a:rPr>
              <a:t> checks </a:t>
            </a:r>
            <a:r>
              <a:rPr sz="1050" dirty="0">
                <a:latin typeface="Arial"/>
                <a:cs typeface="Arial"/>
              </a:rPr>
              <a:t>during</a:t>
            </a:r>
            <a:r>
              <a:rPr sz="1050" spc="-3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eonatal</a:t>
            </a:r>
            <a:r>
              <a:rPr sz="1050" spc="-25" dirty="0">
                <a:latin typeface="Arial"/>
                <a:cs typeface="Arial"/>
              </a:rPr>
              <a:t> CPR</a:t>
            </a:r>
            <a:endParaRPr sz="1050" dirty="0">
              <a:latin typeface="Arial"/>
              <a:cs typeface="Arial"/>
            </a:endParaRPr>
          </a:p>
          <a:p>
            <a:pPr marL="12700" marR="50165">
              <a:lnSpc>
                <a:spcPts val="1210"/>
              </a:lnSpc>
              <a:tabLst>
                <a:tab pos="1144905" algn="l"/>
              </a:tabLst>
            </a:pPr>
            <a:r>
              <a:rPr sz="1050" b="1" dirty="0">
                <a:latin typeface="Arial"/>
                <a:cs typeface="Arial"/>
              </a:rPr>
              <a:t>4.</a:t>
            </a:r>
            <a:r>
              <a:rPr sz="1050" b="1" spc="-2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4</a:t>
            </a:r>
            <a:r>
              <a:rPr sz="1050" spc="-10" dirty="0">
                <a:latin typeface="Arial"/>
                <a:cs typeface="Arial"/>
              </a:rPr>
              <a:t> pre-</a:t>
            </a:r>
            <a:r>
              <a:rPr sz="1050" dirty="0">
                <a:latin typeface="Arial"/>
                <a:cs typeface="Arial"/>
              </a:rPr>
              <a:t>birth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questions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GA,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#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abies,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additional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risk </a:t>
            </a:r>
            <a:r>
              <a:rPr sz="1050" dirty="0">
                <a:latin typeface="Arial"/>
                <a:cs typeface="Arial"/>
              </a:rPr>
              <a:t>factors, is the </a:t>
            </a:r>
            <a:r>
              <a:rPr sz="1050" u="sng" dirty="0">
                <a:uFill>
                  <a:solidFill>
                    <a:srgbClr val="000000"/>
                  </a:solidFill>
                </a:uFill>
                <a:latin typeface="Times New Roman"/>
                <a:cs typeface="Times New Roman"/>
              </a:rPr>
              <a:t>	</a:t>
            </a:r>
            <a:r>
              <a:rPr sz="1050" dirty="0">
                <a:latin typeface="Arial"/>
                <a:cs typeface="Arial"/>
              </a:rPr>
              <a:t>?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(3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words,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o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spaces)</a:t>
            </a:r>
            <a:endParaRPr sz="1050" dirty="0">
              <a:latin typeface="Arial"/>
              <a:cs typeface="Arial"/>
            </a:endParaRPr>
          </a:p>
          <a:p>
            <a:pPr marL="12700" marR="146050" indent="147955">
              <a:lnSpc>
                <a:spcPts val="1210"/>
              </a:lnSpc>
              <a:buFont typeface="Arial"/>
              <a:buAutoNum type="arabicPeriod" startAt="7"/>
              <a:tabLst>
                <a:tab pos="160655" algn="l"/>
              </a:tabLst>
            </a:pPr>
            <a:r>
              <a:rPr sz="1050" dirty="0">
                <a:latin typeface="Arial"/>
                <a:cs typeface="Arial"/>
              </a:rPr>
              <a:t>You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eed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o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uction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h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aby.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pel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h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place </a:t>
            </a:r>
            <a:r>
              <a:rPr sz="1050" dirty="0">
                <a:latin typeface="Arial"/>
                <a:cs typeface="Arial"/>
              </a:rPr>
              <a:t>you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uction</a:t>
            </a:r>
            <a:r>
              <a:rPr sz="1050" spc="-10" dirty="0">
                <a:latin typeface="Arial"/>
                <a:cs typeface="Arial"/>
              </a:rPr>
              <a:t> first</a:t>
            </a:r>
            <a:endParaRPr sz="1050" dirty="0">
              <a:latin typeface="Arial"/>
              <a:cs typeface="Arial"/>
            </a:endParaRPr>
          </a:p>
          <a:p>
            <a:pPr marL="160655" indent="-147955">
              <a:lnSpc>
                <a:spcPts val="1150"/>
              </a:lnSpc>
              <a:buFont typeface="Arial"/>
              <a:buAutoNum type="arabicPeriod" startAt="7"/>
              <a:tabLst>
                <a:tab pos="160655" algn="l"/>
              </a:tabLst>
            </a:pPr>
            <a:r>
              <a:rPr sz="1050" dirty="0">
                <a:latin typeface="Arial"/>
                <a:cs typeface="Arial"/>
              </a:rPr>
              <a:t>Spel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uggested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itial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lang="en-US" sz="1050" spc="-10" dirty="0">
                <a:latin typeface="Arial"/>
                <a:cs typeface="Arial"/>
              </a:rPr>
              <a:t>p</a:t>
            </a:r>
            <a:r>
              <a:rPr lang="en-US" sz="1050" dirty="0">
                <a:latin typeface="Arial"/>
                <a:cs typeface="Arial"/>
              </a:rPr>
              <a:t>ositive end-expiratory pressure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cm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5" dirty="0">
                <a:latin typeface="Arial"/>
                <a:cs typeface="Arial"/>
              </a:rPr>
              <a:t>H2O</a:t>
            </a:r>
            <a:endParaRPr sz="1050" dirty="0">
              <a:latin typeface="Arial"/>
              <a:cs typeface="Arial"/>
            </a:endParaRPr>
          </a:p>
          <a:p>
            <a:pPr marL="12700" marR="71755" indent="147955">
              <a:lnSpc>
                <a:spcPts val="1210"/>
              </a:lnSpc>
              <a:spcBef>
                <a:spcPts val="55"/>
              </a:spcBef>
              <a:buFont typeface="Arial"/>
              <a:buAutoNum type="arabicPeriod" startAt="7"/>
              <a:tabLst>
                <a:tab pos="160655" algn="l"/>
                <a:tab pos="757555" algn="l"/>
              </a:tabLst>
            </a:pPr>
            <a:r>
              <a:rPr sz="1050" dirty="0">
                <a:latin typeface="Arial"/>
                <a:cs typeface="Arial"/>
              </a:rPr>
              <a:t>Indications</a:t>
            </a:r>
            <a:r>
              <a:rPr sz="1050" spc="-2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for</a:t>
            </a:r>
            <a:r>
              <a:rPr sz="1050" spc="-2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positive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pressure</a:t>
            </a:r>
            <a:r>
              <a:rPr sz="1050" spc="-2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ventilation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include </a:t>
            </a:r>
            <a:r>
              <a:rPr sz="1050" dirty="0">
                <a:latin typeface="Arial"/>
                <a:cs typeface="Arial"/>
              </a:rPr>
              <a:t>apnea, </a:t>
            </a:r>
            <a:r>
              <a:rPr sz="1050" u="sng" dirty="0">
                <a:uFill>
                  <a:solidFill>
                    <a:srgbClr val="000000"/>
                  </a:solidFill>
                </a:uFill>
                <a:latin typeface="Times New Roman"/>
                <a:cs typeface="Times New Roman"/>
              </a:rPr>
              <a:t>	</a:t>
            </a:r>
            <a:r>
              <a:rPr sz="1050" dirty="0">
                <a:latin typeface="Arial"/>
                <a:cs typeface="Arial"/>
              </a:rPr>
              <a:t>,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r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HR &lt;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100 </a:t>
            </a:r>
            <a:r>
              <a:rPr sz="1050" spc="-25" dirty="0">
                <a:latin typeface="Arial"/>
                <a:cs typeface="Arial"/>
              </a:rPr>
              <a:t>bpm</a:t>
            </a:r>
            <a:endParaRPr sz="1050" dirty="0">
              <a:latin typeface="Arial"/>
              <a:cs typeface="Arial"/>
            </a:endParaRPr>
          </a:p>
        </p:txBody>
      </p:sp>
      <p:sp>
        <p:nvSpPr>
          <p:cNvPr id="165" name="object 165"/>
          <p:cNvSpPr/>
          <p:nvPr/>
        </p:nvSpPr>
        <p:spPr>
          <a:xfrm>
            <a:off x="4427524" y="5990539"/>
            <a:ext cx="2867660" cy="127000"/>
          </a:xfrm>
          <a:custGeom>
            <a:avLst/>
            <a:gdLst/>
            <a:ahLst/>
            <a:cxnLst/>
            <a:rect l="l" t="t" r="r" b="b"/>
            <a:pathLst>
              <a:path w="2867659" h="127000">
                <a:moveTo>
                  <a:pt x="2867558" y="126796"/>
                </a:moveTo>
                <a:lnTo>
                  <a:pt x="0" y="126796"/>
                </a:lnTo>
                <a:lnTo>
                  <a:pt x="0" y="0"/>
                </a:lnTo>
                <a:lnTo>
                  <a:pt x="2867558" y="0"/>
                </a:lnTo>
                <a:lnTo>
                  <a:pt x="2867558" y="12679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6" name="object 166"/>
          <p:cNvSpPr txBox="1"/>
          <p:nvPr/>
        </p:nvSpPr>
        <p:spPr>
          <a:xfrm>
            <a:off x="4422140" y="5987592"/>
            <a:ext cx="2877820" cy="13398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700" dirty="0">
                <a:solidFill>
                  <a:srgbClr val="686868"/>
                </a:solidFill>
                <a:latin typeface="Verdana"/>
                <a:cs typeface="Verdana"/>
              </a:rPr>
              <a:t>Created using the Crossword</a:t>
            </a:r>
            <a:r>
              <a:rPr sz="700" spc="5" dirty="0">
                <a:solidFill>
                  <a:srgbClr val="686868"/>
                </a:solidFill>
                <a:latin typeface="Verdana"/>
                <a:cs typeface="Verdana"/>
              </a:rPr>
              <a:t> </a:t>
            </a:r>
            <a:r>
              <a:rPr sz="700" dirty="0">
                <a:solidFill>
                  <a:srgbClr val="686868"/>
                </a:solidFill>
                <a:latin typeface="Verdana"/>
                <a:cs typeface="Verdana"/>
              </a:rPr>
              <a:t>Maker on </a:t>
            </a:r>
            <a:r>
              <a:rPr sz="700" spc="-10" dirty="0">
                <a:solidFill>
                  <a:srgbClr val="686868"/>
                </a:solidFill>
                <a:latin typeface="Verdana"/>
                <a:cs typeface="Verdana"/>
              </a:rPr>
              <a:t>TheTeachersCorner.net</a:t>
            </a:r>
            <a:endParaRPr sz="700">
              <a:latin typeface="Verdana"/>
              <a:cs typeface="Verdana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</TotalTime>
  <Words>243</Words>
  <Application>Microsoft Macintosh PowerPoint</Application>
  <PresentationFormat>Custom</PresentationFormat>
  <Paragraphs>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ourier New</vt:lpstr>
      <vt:lpstr>Times New Roman</vt:lpstr>
      <vt:lpstr>Verdan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RP Crossword</dc:title>
  <cp:lastModifiedBy>Patricia Hartz</cp:lastModifiedBy>
  <cp:revision>2</cp:revision>
  <dcterms:created xsi:type="dcterms:W3CDTF">2023-08-23T00:24:19Z</dcterms:created>
  <dcterms:modified xsi:type="dcterms:W3CDTF">2023-10-10T23:52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3-01-07T00:00:00Z</vt:filetime>
  </property>
  <property fmtid="{D5CDD505-2E9C-101B-9397-08002B2CF9AE}" pid="3" name="Creator">
    <vt:lpwstr>wkhtmltopdf 0.12.6</vt:lpwstr>
  </property>
  <property fmtid="{D5CDD505-2E9C-101B-9397-08002B2CF9AE}" pid="4" name="Producer">
    <vt:lpwstr>Qt 4.8.7</vt:lpwstr>
  </property>
  <property fmtid="{D5CDD505-2E9C-101B-9397-08002B2CF9AE}" pid="5" name="LastSaved">
    <vt:filetime>2023-01-07T00:00:00Z</vt:filetime>
  </property>
</Properties>
</file>